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ppt/diagrams/data9.xml" ContentType="application/vnd.openxmlformats-officedocument.drawingml.diagramData+xml"/>
  <Override PartName="/ppt/diagrams/layout9.xml" ContentType="application/vnd.openxmlformats-officedocument.drawingml.diagramLayout+xml"/>
  <Override PartName="/ppt/diagrams/quickStyle9.xml" ContentType="application/vnd.openxmlformats-officedocument.drawingml.diagramStyle+xml"/>
  <Override PartName="/ppt/diagrams/colors9.xml" ContentType="application/vnd.openxmlformats-officedocument.drawingml.diagramColors+xml"/>
  <Override PartName="/ppt/diagrams/drawing9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9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1285A5-BDA8-4319-9B18-A272AE807501}">
      <dgm:prSet phldrT="[Texto]" custT="1"/>
      <dgm:spPr/>
      <dgm:t>
        <a:bodyPr/>
        <a:lstStyle/>
        <a:p>
          <a:r>
            <a:rPr lang="es-ES" sz="700" dirty="0" err="1" smtClean="0"/>
            <a:t>Downturned</a:t>
          </a:r>
          <a:r>
            <a:rPr lang="es-ES" sz="700" dirty="0" smtClean="0"/>
            <a:t> </a:t>
          </a:r>
          <a:r>
            <a:rPr lang="es-ES" sz="700" dirty="0" err="1" smtClean="0"/>
            <a:t>corners</a:t>
          </a:r>
          <a:r>
            <a:rPr lang="es-ES" sz="700" dirty="0" smtClean="0"/>
            <a:t> </a:t>
          </a:r>
        </a:p>
        <a:p>
          <a:r>
            <a:rPr lang="es-ES" sz="700" dirty="0" smtClean="0"/>
            <a:t>of the </a:t>
          </a:r>
          <a:r>
            <a:rPr lang="es-ES" sz="700" dirty="0" err="1" smtClean="0"/>
            <a:t>mouth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C83CB-467D-45AD-848C-3AFEDEE37424}" type="par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C9E6D4-16C4-41BD-964C-0D4FE940A841}" type="sib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F307E38-E9EA-48C7-BB5D-7186A49E7AB2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752D029-C0D8-438D-BDDF-ADBDBB5D708A}" type="par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385C5A4-42F9-4644-9246-1AF9FC506284}" type="sib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Light ID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Rou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F58F62-2558-46D7-A230-720F7B055378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Dental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6718D0-449E-496D-8D69-A4AC9344CE34}" type="par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8D8F35-9B11-49D3-8837-BDCBC81252A7}" type="sib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/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/>
        </a:p>
      </dgm:t>
    </dgm:pt>
    <dgm:pt modelId="{D655FC61-77AB-474C-87EC-65CEF9F0AFE0}">
      <dgm:prSet phldrT="[Texto]"/>
      <dgm:spPr/>
      <dgm:t>
        <a:bodyPr/>
        <a:lstStyle/>
        <a:p>
          <a:r>
            <a:rPr lang="es-ES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0FDC6B-04CF-4EB8-BD67-90C9D623F3AF}" type="parTrans" cxnId="{F9916CE0-7462-417D-BB07-48411A2AB4D1}">
      <dgm:prSet/>
      <dgm:spPr/>
      <dgm:t>
        <a:bodyPr/>
        <a:lstStyle/>
        <a:p>
          <a:endParaRPr lang="es-ES"/>
        </a:p>
      </dgm:t>
    </dgm:pt>
    <dgm:pt modelId="{4B18C9CE-79C0-4C3C-BB08-DA387AFD666C}" type="sibTrans" cxnId="{F9916CE0-7462-417D-BB07-48411A2AB4D1}">
      <dgm:prSet/>
      <dgm:spPr/>
      <dgm:t>
        <a:bodyPr/>
        <a:lstStyle/>
        <a:p>
          <a:endParaRPr lang="es-ES"/>
        </a:p>
      </dgm:t>
    </dgm:pt>
    <dgm:pt modelId="{E3F7EF6D-D1CE-43BF-9EED-CCEADA0930F4}">
      <dgm:prSet phldrT="[Texto]"/>
      <dgm:spPr/>
      <dgm:t>
        <a:bodyPr/>
        <a:lstStyle/>
        <a:p>
          <a:r>
            <a:rPr lang="es-ES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/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/>
        </a:p>
      </dgm:t>
    </dgm:pt>
    <dgm:pt modelId="{FC7903FA-6757-49A7-9625-6E4B010FEF03}">
      <dgm:prSet phldrT="[Texto]"/>
      <dgm:spPr/>
      <dgm:t>
        <a:bodyPr/>
        <a:lstStyle/>
        <a:p>
          <a:r>
            <a:rPr lang="es-ES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F767A8-458F-48C0-B779-475106FA88B7}" type="parTrans" cxnId="{F1DFCA33-F551-4F55-960D-C7C29DD0C83B}">
      <dgm:prSet/>
      <dgm:spPr/>
      <dgm:t>
        <a:bodyPr/>
        <a:lstStyle/>
        <a:p>
          <a:endParaRPr lang="es-ES"/>
        </a:p>
      </dgm:t>
    </dgm:pt>
    <dgm:pt modelId="{5915D032-3986-42FD-BC78-4F708CC457CB}" type="sibTrans" cxnId="{F1DFCA33-F551-4F55-960D-C7C29DD0C83B}">
      <dgm:prSet/>
      <dgm:spPr/>
      <dgm:t>
        <a:bodyPr/>
        <a:lstStyle/>
        <a:p>
          <a:endParaRPr lang="es-ES"/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11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11" custScaleX="139601" custRadScaleRad="100708" custRadScaleInc="-20129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9770CDF7-8417-4BBA-9FBC-F8390177E143}" type="pres">
      <dgm:prSet presAssocID="{FC7903FA-6757-49A7-9625-6E4B010FEF03}" presName="node" presStyleLbl="vennNode1" presStyleIdx="2" presStyleCnt="11" custRadScaleRad="114034" custRadScaleInc="-21826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8262EBD1-2017-484A-9727-5BB0DEA45C1E}" type="pres">
      <dgm:prSet presAssocID="{1A1285A5-BDA8-4319-9B18-A272AE807501}" presName="node" presStyleLbl="vennNode1" presStyleIdx="3" presStyleCnt="11" custScaleX="133921" custRadScaleRad="108520" custRadScaleInc="-21378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4" presStyleCnt="11" custScaleX="117356" custRadScaleRad="107319" custRadScaleInc="-13275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2EDB95F-2EA1-401F-AF4F-043134B29286}" type="pres">
      <dgm:prSet presAssocID="{FF307E38-E9EA-48C7-BB5D-7186A49E7AB2}" presName="node" presStyleLbl="vennNode1" presStyleIdx="5" presStyleCnt="11" custScaleX="127615" custRadScaleRad="96005" custRadScaleInc="-1089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6" presStyleCnt="11" custRadScaleRad="103407" custRadScaleInc="-642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28C80B8C-BF19-4581-9A31-F40D8D8E3B6C}" type="pres">
      <dgm:prSet presAssocID="{D655FC61-77AB-474C-87EC-65CEF9F0AFE0}" presName="node" presStyleLbl="vennNode1" presStyleIdx="7" presStyleCnt="1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8" presStyleCnt="11" custRadScaleRad="99732" custRadScaleInc="351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9" presStyleCnt="11" custRadScaleRad="110892" custRadScaleInc="27934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CEE8EC5F-8DBF-44DF-8446-C990E41D50F6}" type="pres">
      <dgm:prSet presAssocID="{29F58F62-2558-46D7-A230-720F7B055378}" presName="node" presStyleLbl="vennNode1" presStyleIdx="10" presStyleCnt="11" custScaleX="119014" custRadScaleRad="93556" custRadScaleInc="35612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7C661AD3-F57A-467E-ABFC-768360D64CAF}" type="presOf" srcId="{0527C542-23FD-4E97-9F9F-A34A08934BE5}" destId="{0D2FAAFB-6C18-4DA1-95E4-D13601D68C8A}" srcOrd="0" destOrd="0" presId="urn:microsoft.com/office/officeart/2005/8/layout/radial3"/>
    <dgm:cxn modelId="{F4A2EE42-9A1C-4D9A-A369-6256A79079BC}" type="presOf" srcId="{FC7903FA-6757-49A7-9625-6E4B010FEF03}" destId="{9770CDF7-8417-4BBA-9FBC-F8390177E143}" srcOrd="0" destOrd="0" presId="urn:microsoft.com/office/officeart/2005/8/layout/radial3"/>
    <dgm:cxn modelId="{8262F093-2723-4563-9311-35F4AE8B7EAE}" type="presOf" srcId="{C72F6624-5DD3-4F43-A003-0ED4444787BB}" destId="{2D3A3C69-23CC-4073-9BB5-7173DB1B5AC6}" srcOrd="0" destOrd="0" presId="urn:microsoft.com/office/officeart/2005/8/layout/radial3"/>
    <dgm:cxn modelId="{8CF85736-7CCD-4CE1-AB59-1955CA974CED}" type="presOf" srcId="{50C9D290-0252-410F-A1BD-454CF787ADC8}" destId="{C7869398-6C49-4AB9-8205-101672020437}" srcOrd="0" destOrd="0" presId="urn:microsoft.com/office/officeart/2005/8/layout/radial3"/>
    <dgm:cxn modelId="{B4D89F05-3988-4F3A-A6E1-B9FFF92B53B3}" type="presOf" srcId="{29F58F62-2558-46D7-A230-720F7B055378}" destId="{CEE8EC5F-8DBF-44DF-8446-C990E41D50F6}" srcOrd="0" destOrd="0" presId="urn:microsoft.com/office/officeart/2005/8/layout/radial3"/>
    <dgm:cxn modelId="{F9916CE0-7462-417D-BB07-48411A2AB4D1}" srcId="{50C9D290-0252-410F-A1BD-454CF787ADC8}" destId="{D655FC61-77AB-474C-87EC-65CEF9F0AFE0}" srcOrd="6" destOrd="0" parTransId="{080FDC6B-04CF-4EB8-BD67-90C9D623F3AF}" sibTransId="{4B18C9CE-79C0-4C3C-BB08-DA387AFD666C}"/>
    <dgm:cxn modelId="{DE2C4248-750A-4A58-9493-B1BB87906778}" srcId="{50C9D290-0252-410F-A1BD-454CF787ADC8}" destId="{0527C542-23FD-4E97-9F9F-A34A08934BE5}" srcOrd="8" destOrd="0" parTransId="{5A7F3E19-4746-495F-AEC8-77E3AB4066C6}" sibTransId="{D0B1DDB7-ED91-4CF5-8E22-D433DAD15D99}"/>
    <dgm:cxn modelId="{89563F23-3083-4105-90D4-E05DCE335D98}" type="presOf" srcId="{D6F84C29-B6D5-4E7D-BDD6-569F8EC9E27C}" destId="{614F53D1-4287-4607-B43A-D85A0FCF661E}" srcOrd="0" destOrd="0" presId="urn:microsoft.com/office/officeart/2005/8/layout/radial3"/>
    <dgm:cxn modelId="{6730B51A-D3F4-4D62-91A2-B9B12BB579E1}" type="presOf" srcId="{A90C8DF0-9A4B-41D3-A6EB-D9A783D586B9}" destId="{8EF7DFA6-5C81-4E45-BE91-EE20E9FAE56A}" srcOrd="0" destOrd="0" presId="urn:microsoft.com/office/officeart/2005/8/layout/radial3"/>
    <dgm:cxn modelId="{DA09C40E-C23D-414E-BC77-034D732CAFF8}" type="presOf" srcId="{E3F7EF6D-D1CE-43BF-9EED-CCEADA0930F4}" destId="{ADF31E19-3513-45A4-9241-2348A1B01016}" srcOrd="0" destOrd="0" presId="urn:microsoft.com/office/officeart/2005/8/layout/radial3"/>
    <dgm:cxn modelId="{B6750CD8-014E-443D-92FE-E3E23E4B21BA}" srcId="{50C9D290-0252-410F-A1BD-454CF787ADC8}" destId="{1A1285A5-BDA8-4319-9B18-A272AE807501}" srcOrd="2" destOrd="0" parTransId="{E26C83CB-467D-45AD-848C-3AFEDEE37424}" sibTransId="{A9C9E6D4-16C4-41BD-964C-0D4FE940A841}"/>
    <dgm:cxn modelId="{7C52A876-6248-4650-90E3-D50FC1908B5B}" srcId="{50C9D290-0252-410F-A1BD-454CF787ADC8}" destId="{B46FB715-7AFC-451B-9469-DD324419BDC1}" srcOrd="7" destOrd="0" parTransId="{E0CE2B5E-4E85-46A0-8B69-7163AB1BDCA6}" sibTransId="{BC5E5B88-F594-4024-99F1-EA04404C6DF2}"/>
    <dgm:cxn modelId="{6EB1E9E6-546F-4EE9-AE9D-6F51C79A5142}" type="presOf" srcId="{1A1285A5-BDA8-4319-9B18-A272AE807501}" destId="{8262EBD1-2017-484A-9727-5BB0DEA45C1E}" srcOrd="0" destOrd="0" presId="urn:microsoft.com/office/officeart/2005/8/layout/radial3"/>
    <dgm:cxn modelId="{6F4C2046-8215-467E-937E-37F8FE1F4FE8}" type="presOf" srcId="{D655FC61-77AB-474C-87EC-65CEF9F0AFE0}" destId="{28C80B8C-BF19-4581-9A31-F40D8D8E3B6C}" srcOrd="0" destOrd="0" presId="urn:microsoft.com/office/officeart/2005/8/layout/radial3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F1DFCA33-F551-4F55-960D-C7C29DD0C83B}" srcId="{50C9D290-0252-410F-A1BD-454CF787ADC8}" destId="{FC7903FA-6757-49A7-9625-6E4B010FEF03}" srcOrd="1" destOrd="0" parTransId="{B8F767A8-458F-48C0-B779-475106FA88B7}" sibTransId="{5915D032-3986-42FD-BC78-4F708CC457CB}"/>
    <dgm:cxn modelId="{B3C6C3F4-339C-44C2-B325-F6CCAE3FDDF9}" srcId="{50C9D290-0252-410F-A1BD-454CF787ADC8}" destId="{FF307E38-E9EA-48C7-BB5D-7186A49E7AB2}" srcOrd="4" destOrd="0" parTransId="{E752D029-C0D8-438D-BDDF-ADBDBB5D708A}" sibTransId="{B385C5A4-42F9-4644-9246-1AF9FC506284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2807979B-DB73-4C65-8016-1F9A073BF01C}" type="presOf" srcId="{FF307E38-E9EA-48C7-BB5D-7186A49E7AB2}" destId="{72EDB95F-2EA1-401F-AF4F-043134B29286}" srcOrd="0" destOrd="0" presId="urn:microsoft.com/office/officeart/2005/8/layout/radial3"/>
    <dgm:cxn modelId="{FB3AD17A-4809-4442-8AA9-D7EA02922DD1}" type="presOf" srcId="{B46FB715-7AFC-451B-9469-DD324419BDC1}" destId="{DE96DFF5-015F-4F59-A3BB-E4577278E7CE}" srcOrd="0" destOrd="0" presId="urn:microsoft.com/office/officeart/2005/8/layout/radial3"/>
    <dgm:cxn modelId="{4FB4442C-5614-4E26-A1E8-CBE28EF8FFBB}" srcId="{50C9D290-0252-410F-A1BD-454CF787ADC8}" destId="{D6F84C29-B6D5-4E7D-BDD6-569F8EC9E27C}" srcOrd="5" destOrd="0" parTransId="{50857628-DD61-4A89-861A-FD844547EBD0}" sibTransId="{903494E9-1B93-4790-87F7-6187FC54F61D}"/>
    <dgm:cxn modelId="{1B83F487-009E-4022-97A4-F5F23B18BABB}" srcId="{50C9D290-0252-410F-A1BD-454CF787ADC8}" destId="{29F58F62-2558-46D7-A230-720F7B055378}" srcOrd="9" destOrd="0" parTransId="{386718D0-449E-496D-8D69-A4AC9344CE34}" sibTransId="{2E8D8F35-9B11-49D3-8837-BDCBC81252A7}"/>
    <dgm:cxn modelId="{6B30FDDE-89C1-4A42-88DB-0E4BB91426C2}" srcId="{50C9D290-0252-410F-A1BD-454CF787ADC8}" destId="{E3F7EF6D-D1CE-43BF-9EED-CCEADA0930F4}" srcOrd="3" destOrd="0" parTransId="{A8EC8D59-92BD-4DB8-B755-C2D0942606BB}" sibTransId="{6DF65815-CAEA-498B-A0ED-E0A39EA33A85}"/>
    <dgm:cxn modelId="{4A0F1162-D8A5-47FB-9C63-E7040AA2CC76}" type="presParOf" srcId="{2D3A3C69-23CC-4073-9BB5-7173DB1B5AC6}" destId="{47F6CD61-8625-493D-AAC4-E6F2B2EEE924}" srcOrd="0" destOrd="0" presId="urn:microsoft.com/office/officeart/2005/8/layout/radial3"/>
    <dgm:cxn modelId="{CF193461-5F4C-4453-9ACC-810FF7BE13A7}" type="presParOf" srcId="{47F6CD61-8625-493D-AAC4-E6F2B2EEE924}" destId="{C7869398-6C49-4AB9-8205-101672020437}" srcOrd="0" destOrd="0" presId="urn:microsoft.com/office/officeart/2005/8/layout/radial3"/>
    <dgm:cxn modelId="{567A7E7A-FCA0-48F9-9E3D-18DC11D4E95C}" type="presParOf" srcId="{47F6CD61-8625-493D-AAC4-E6F2B2EEE924}" destId="{8EF7DFA6-5C81-4E45-BE91-EE20E9FAE56A}" srcOrd="1" destOrd="0" presId="urn:microsoft.com/office/officeart/2005/8/layout/radial3"/>
    <dgm:cxn modelId="{BD1E1F76-BBF4-4693-9F0F-5CF81585F669}" type="presParOf" srcId="{47F6CD61-8625-493D-AAC4-E6F2B2EEE924}" destId="{9770CDF7-8417-4BBA-9FBC-F8390177E143}" srcOrd="2" destOrd="0" presId="urn:microsoft.com/office/officeart/2005/8/layout/radial3"/>
    <dgm:cxn modelId="{55EB7BCA-52BE-4C17-AD15-018E88574936}" type="presParOf" srcId="{47F6CD61-8625-493D-AAC4-E6F2B2EEE924}" destId="{8262EBD1-2017-484A-9727-5BB0DEA45C1E}" srcOrd="3" destOrd="0" presId="urn:microsoft.com/office/officeart/2005/8/layout/radial3"/>
    <dgm:cxn modelId="{48814EC0-D759-47E8-899D-D354ED22D80F}" type="presParOf" srcId="{47F6CD61-8625-493D-AAC4-E6F2B2EEE924}" destId="{ADF31E19-3513-45A4-9241-2348A1B01016}" srcOrd="4" destOrd="0" presId="urn:microsoft.com/office/officeart/2005/8/layout/radial3"/>
    <dgm:cxn modelId="{BBA49C32-F4FA-49A9-B3A5-BCB1C7F69B31}" type="presParOf" srcId="{47F6CD61-8625-493D-AAC4-E6F2B2EEE924}" destId="{72EDB95F-2EA1-401F-AF4F-043134B29286}" srcOrd="5" destOrd="0" presId="urn:microsoft.com/office/officeart/2005/8/layout/radial3"/>
    <dgm:cxn modelId="{3B5765DC-783A-4111-AE3C-B0D206343BE4}" type="presParOf" srcId="{47F6CD61-8625-493D-AAC4-E6F2B2EEE924}" destId="{614F53D1-4287-4607-B43A-D85A0FCF661E}" srcOrd="6" destOrd="0" presId="urn:microsoft.com/office/officeart/2005/8/layout/radial3"/>
    <dgm:cxn modelId="{460B7561-1B61-4C3D-9A1C-ACFAAD2D5A40}" type="presParOf" srcId="{47F6CD61-8625-493D-AAC4-E6F2B2EEE924}" destId="{28C80B8C-BF19-4581-9A31-F40D8D8E3B6C}" srcOrd="7" destOrd="0" presId="urn:microsoft.com/office/officeart/2005/8/layout/radial3"/>
    <dgm:cxn modelId="{71EC5B8B-73C0-462E-A965-80900DE2C198}" type="presParOf" srcId="{47F6CD61-8625-493D-AAC4-E6F2B2EEE924}" destId="{DE96DFF5-015F-4F59-A3BB-E4577278E7CE}" srcOrd="8" destOrd="0" presId="urn:microsoft.com/office/officeart/2005/8/layout/radial3"/>
    <dgm:cxn modelId="{A0217AAB-2328-45C3-9985-DD93F1B3261F}" type="presParOf" srcId="{47F6CD61-8625-493D-AAC4-E6F2B2EEE924}" destId="{0D2FAAFB-6C18-4DA1-95E4-D13601D68C8A}" srcOrd="9" destOrd="0" presId="urn:microsoft.com/office/officeart/2005/8/layout/radial3"/>
    <dgm:cxn modelId="{405AE639-30AC-4753-B725-E4F6A9CF7367}" type="presParOf" srcId="{47F6CD61-8625-493D-AAC4-E6F2B2EEE924}" destId="{CEE8EC5F-8DBF-44DF-8446-C990E41D50F6}" srcOrd="10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1285A5-BDA8-4319-9B18-A272AE807501}">
      <dgm:prSet phldrT="[Texto]" custT="1"/>
      <dgm:spPr/>
      <dgm:t>
        <a:bodyPr/>
        <a:lstStyle/>
        <a:p>
          <a:r>
            <a:rPr lang="es-ES" sz="700" dirty="0" err="1" smtClean="0"/>
            <a:t>Auditive</a:t>
          </a:r>
          <a:r>
            <a:rPr lang="es-ES" sz="700" dirty="0" smtClean="0"/>
            <a:t> </a:t>
          </a:r>
          <a:r>
            <a:rPr lang="es-ES" sz="700" dirty="0" err="1" smtClean="0"/>
            <a:t>problem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C83CB-467D-45AD-848C-3AFEDEE37424}" type="par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C9E6D4-16C4-41BD-964C-0D4FE940A841}" type="sib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F307E38-E9EA-48C7-BB5D-7186A49E7AB2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to be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seated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752D029-C0D8-438D-BDDF-ADBDBB5D708A}" type="par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385C5A4-42F9-4644-9246-1AF9FC506284}" type="sib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Use of </a:t>
          </a:r>
          <a:r>
            <a:rPr lang="es-ES" sz="600" dirty="0" err="1" smtClean="0">
              <a:latin typeface="Arial" panose="020B0604020202020204" pitchFamily="34" charset="0"/>
              <a:cs typeface="Arial" panose="020B0604020202020204" pitchFamily="34" charset="0"/>
            </a:rPr>
            <a:t>alternative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ommun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.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tool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F58F62-2558-46D7-A230-720F7B055378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6718D0-449E-496D-8D69-A4AC9344CE34}" type="par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8D8F35-9B11-49D3-8837-BDCBC81252A7}" type="sib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/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/>
        </a:p>
      </dgm:t>
    </dgm:pt>
    <dgm:pt modelId="{D655FC61-77AB-474C-87EC-65CEF9F0AFE0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0FDC6B-04CF-4EB8-BD67-90C9D623F3AF}" type="parTrans" cxnId="{F9916CE0-7462-417D-BB07-48411A2AB4D1}">
      <dgm:prSet/>
      <dgm:spPr/>
      <dgm:t>
        <a:bodyPr/>
        <a:lstStyle/>
        <a:p>
          <a:endParaRPr lang="es-ES"/>
        </a:p>
      </dgm:t>
    </dgm:pt>
    <dgm:pt modelId="{4B18C9CE-79C0-4C3C-BB08-DA387AFD666C}" type="sibTrans" cxnId="{F9916CE0-7462-417D-BB07-48411A2AB4D1}">
      <dgm:prSet/>
      <dgm:spPr/>
      <dgm:t>
        <a:bodyPr/>
        <a:lstStyle/>
        <a:p>
          <a:endParaRPr lang="es-ES"/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/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/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10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10" custScaleX="132772" custRadScaleRad="105630" custRadScaleInc="-12007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8262EBD1-2017-484A-9727-5BB0DEA45C1E}" type="pres">
      <dgm:prSet presAssocID="{1A1285A5-BDA8-4319-9B18-A272AE807501}" presName="node" presStyleLbl="vennNode1" presStyleIdx="2" presStyleCnt="10" custScaleX="117356" custRadScaleRad="106564" custRadScaleInc="-138876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3" presStyleCnt="10" custScaleX="117356" custRadScaleRad="107319" custRadScaleInc="-13275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2EDB95F-2EA1-401F-AF4F-043134B29286}" type="pres">
      <dgm:prSet presAssocID="{FF307E38-E9EA-48C7-BB5D-7186A49E7AB2}" presName="node" presStyleLbl="vennNode1" presStyleIdx="4" presStyleCnt="10" custRadScaleRad="96005" custRadScaleInc="-1089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5" presStyleCnt="10" custScaleX="129220" custRadScaleRad="103407" custRadScaleInc="-642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28C80B8C-BF19-4581-9A31-F40D8D8E3B6C}" type="pres">
      <dgm:prSet presAssocID="{D655FC61-77AB-474C-87EC-65CEF9F0AFE0}" presName="node" presStyleLbl="vennNode1" presStyleIdx="6" presStyleCnt="10" custScaleX="134886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7" presStyleCnt="1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8" presStyleCnt="10" custScaleX="138813" custRadScaleRad="107478" custRadScaleInc="162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CEE8EC5F-8DBF-44DF-8446-C990E41D50F6}" type="pres">
      <dgm:prSet presAssocID="{29F58F62-2558-46D7-A230-720F7B055378}" presName="node" presStyleLbl="vennNode1" presStyleIdx="9" presStyleCnt="10" custRadScaleRad="94809" custRadScaleInc="27216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4ADA24B7-A810-4804-BD81-DD15E0FCF0FF}" type="presOf" srcId="{E3F7EF6D-D1CE-43BF-9EED-CCEADA0930F4}" destId="{ADF31E19-3513-45A4-9241-2348A1B01016}" srcOrd="0" destOrd="0" presId="urn:microsoft.com/office/officeart/2005/8/layout/radial3"/>
    <dgm:cxn modelId="{391A8A1E-0574-4D82-A88F-75A637751D68}" type="presOf" srcId="{B46FB715-7AFC-451B-9469-DD324419BDC1}" destId="{DE96DFF5-015F-4F59-A3BB-E4577278E7CE}" srcOrd="0" destOrd="0" presId="urn:microsoft.com/office/officeart/2005/8/layout/radial3"/>
    <dgm:cxn modelId="{D5360884-1FA4-4E37-BCCA-B625FF0E11BF}" type="presOf" srcId="{A90C8DF0-9A4B-41D3-A6EB-D9A783D586B9}" destId="{8EF7DFA6-5C81-4E45-BE91-EE20E9FAE56A}" srcOrd="0" destOrd="0" presId="urn:microsoft.com/office/officeart/2005/8/layout/radial3"/>
    <dgm:cxn modelId="{F9916CE0-7462-417D-BB07-48411A2AB4D1}" srcId="{50C9D290-0252-410F-A1BD-454CF787ADC8}" destId="{D655FC61-77AB-474C-87EC-65CEF9F0AFE0}" srcOrd="5" destOrd="0" parTransId="{080FDC6B-04CF-4EB8-BD67-90C9D623F3AF}" sibTransId="{4B18C9CE-79C0-4C3C-BB08-DA387AFD666C}"/>
    <dgm:cxn modelId="{57A235D5-3F44-4BD7-8432-7DD99FD37F97}" type="presOf" srcId="{50C9D290-0252-410F-A1BD-454CF787ADC8}" destId="{C7869398-6C49-4AB9-8205-101672020437}" srcOrd="0" destOrd="0" presId="urn:microsoft.com/office/officeart/2005/8/layout/radial3"/>
    <dgm:cxn modelId="{DE2C4248-750A-4A58-9493-B1BB87906778}" srcId="{50C9D290-0252-410F-A1BD-454CF787ADC8}" destId="{0527C542-23FD-4E97-9F9F-A34A08934BE5}" srcOrd="7" destOrd="0" parTransId="{5A7F3E19-4746-495F-AEC8-77E3AB4066C6}" sibTransId="{D0B1DDB7-ED91-4CF5-8E22-D433DAD15D99}"/>
    <dgm:cxn modelId="{7C52A876-6248-4650-90E3-D50FC1908B5B}" srcId="{50C9D290-0252-410F-A1BD-454CF787ADC8}" destId="{B46FB715-7AFC-451B-9469-DD324419BDC1}" srcOrd="6" destOrd="0" parTransId="{E0CE2B5E-4E85-46A0-8B69-7163AB1BDCA6}" sibTransId="{BC5E5B88-F594-4024-99F1-EA04404C6DF2}"/>
    <dgm:cxn modelId="{B6750CD8-014E-443D-92FE-E3E23E4B21BA}" srcId="{50C9D290-0252-410F-A1BD-454CF787ADC8}" destId="{1A1285A5-BDA8-4319-9B18-A272AE807501}" srcOrd="1" destOrd="0" parTransId="{E26C83CB-467D-45AD-848C-3AFEDEE37424}" sibTransId="{A9C9E6D4-16C4-41BD-964C-0D4FE940A841}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218EB7B0-A6E5-4810-BC9E-E18D276AC891}" type="presOf" srcId="{29F58F62-2558-46D7-A230-720F7B055378}" destId="{CEE8EC5F-8DBF-44DF-8446-C990E41D50F6}" srcOrd="0" destOrd="0" presId="urn:microsoft.com/office/officeart/2005/8/layout/radial3"/>
    <dgm:cxn modelId="{D393DC17-5F14-49F2-AEF7-09414349FCCD}" type="presOf" srcId="{FF307E38-E9EA-48C7-BB5D-7186A49E7AB2}" destId="{72EDB95F-2EA1-401F-AF4F-043134B29286}" srcOrd="0" destOrd="0" presId="urn:microsoft.com/office/officeart/2005/8/layout/radial3"/>
    <dgm:cxn modelId="{B3C6C3F4-339C-44C2-B325-F6CCAE3FDDF9}" srcId="{50C9D290-0252-410F-A1BD-454CF787ADC8}" destId="{FF307E38-E9EA-48C7-BB5D-7186A49E7AB2}" srcOrd="3" destOrd="0" parTransId="{E752D029-C0D8-438D-BDDF-ADBDBB5D708A}" sibTransId="{B385C5A4-42F9-4644-9246-1AF9FC506284}"/>
    <dgm:cxn modelId="{06BE2BDF-6F51-42CA-8176-DECE67AB6633}" type="presOf" srcId="{D655FC61-77AB-474C-87EC-65CEF9F0AFE0}" destId="{28C80B8C-BF19-4581-9A31-F40D8D8E3B6C}" srcOrd="0" destOrd="0" presId="urn:microsoft.com/office/officeart/2005/8/layout/radial3"/>
    <dgm:cxn modelId="{937B05A7-B39C-4C73-8BF5-7EB0C2EA0CE0}" type="presOf" srcId="{D6F84C29-B6D5-4E7D-BDD6-569F8EC9E27C}" destId="{614F53D1-4287-4607-B43A-D85A0FCF661E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1A2A04D3-8197-4D7A-81C4-B6BAB7E1FE4A}" type="presOf" srcId="{1A1285A5-BDA8-4319-9B18-A272AE807501}" destId="{8262EBD1-2017-484A-9727-5BB0DEA45C1E}" srcOrd="0" destOrd="0" presId="urn:microsoft.com/office/officeart/2005/8/layout/radial3"/>
    <dgm:cxn modelId="{4FB4442C-5614-4E26-A1E8-CBE28EF8FFBB}" srcId="{50C9D290-0252-410F-A1BD-454CF787ADC8}" destId="{D6F84C29-B6D5-4E7D-BDD6-569F8EC9E27C}" srcOrd="4" destOrd="0" parTransId="{50857628-DD61-4A89-861A-FD844547EBD0}" sibTransId="{903494E9-1B93-4790-87F7-6187FC54F61D}"/>
    <dgm:cxn modelId="{1B83F487-009E-4022-97A4-F5F23B18BABB}" srcId="{50C9D290-0252-410F-A1BD-454CF787ADC8}" destId="{29F58F62-2558-46D7-A230-720F7B055378}" srcOrd="8" destOrd="0" parTransId="{386718D0-449E-496D-8D69-A4AC9344CE34}" sibTransId="{2E8D8F35-9B11-49D3-8837-BDCBC81252A7}"/>
    <dgm:cxn modelId="{6B30FDDE-89C1-4A42-88DB-0E4BB91426C2}" srcId="{50C9D290-0252-410F-A1BD-454CF787ADC8}" destId="{E3F7EF6D-D1CE-43BF-9EED-CCEADA0930F4}" srcOrd="2" destOrd="0" parTransId="{A8EC8D59-92BD-4DB8-B755-C2D0942606BB}" sibTransId="{6DF65815-CAEA-498B-A0ED-E0A39EA33A85}"/>
    <dgm:cxn modelId="{236FE92B-0D1F-4C92-B7FF-DC109A258222}" type="presOf" srcId="{0527C542-23FD-4E97-9F9F-A34A08934BE5}" destId="{0D2FAAFB-6C18-4DA1-95E4-D13601D68C8A}" srcOrd="0" destOrd="0" presId="urn:microsoft.com/office/officeart/2005/8/layout/radial3"/>
    <dgm:cxn modelId="{5DDB2DD7-F127-4E9E-A5B4-37E17742F331}" type="presOf" srcId="{C72F6624-5DD3-4F43-A003-0ED4444787BB}" destId="{2D3A3C69-23CC-4073-9BB5-7173DB1B5AC6}" srcOrd="0" destOrd="0" presId="urn:microsoft.com/office/officeart/2005/8/layout/radial3"/>
    <dgm:cxn modelId="{9A21EBA4-952B-46A9-A5C3-1A3709DE3B44}" type="presParOf" srcId="{2D3A3C69-23CC-4073-9BB5-7173DB1B5AC6}" destId="{47F6CD61-8625-493D-AAC4-E6F2B2EEE924}" srcOrd="0" destOrd="0" presId="urn:microsoft.com/office/officeart/2005/8/layout/radial3"/>
    <dgm:cxn modelId="{D177B7E9-C127-482F-82A8-66BE76AEE125}" type="presParOf" srcId="{47F6CD61-8625-493D-AAC4-E6F2B2EEE924}" destId="{C7869398-6C49-4AB9-8205-101672020437}" srcOrd="0" destOrd="0" presId="urn:microsoft.com/office/officeart/2005/8/layout/radial3"/>
    <dgm:cxn modelId="{C36EF82B-5426-4473-A575-21425110A022}" type="presParOf" srcId="{47F6CD61-8625-493D-AAC4-E6F2B2EEE924}" destId="{8EF7DFA6-5C81-4E45-BE91-EE20E9FAE56A}" srcOrd="1" destOrd="0" presId="urn:microsoft.com/office/officeart/2005/8/layout/radial3"/>
    <dgm:cxn modelId="{BF0857BF-CD46-45EB-8ED0-8FBB72327A0F}" type="presParOf" srcId="{47F6CD61-8625-493D-AAC4-E6F2B2EEE924}" destId="{8262EBD1-2017-484A-9727-5BB0DEA45C1E}" srcOrd="2" destOrd="0" presId="urn:microsoft.com/office/officeart/2005/8/layout/radial3"/>
    <dgm:cxn modelId="{BAA5DC40-70FA-4167-910B-B9D8964E39A6}" type="presParOf" srcId="{47F6CD61-8625-493D-AAC4-E6F2B2EEE924}" destId="{ADF31E19-3513-45A4-9241-2348A1B01016}" srcOrd="3" destOrd="0" presId="urn:microsoft.com/office/officeart/2005/8/layout/radial3"/>
    <dgm:cxn modelId="{823B5B90-2C81-4341-B7FA-2A9452A1ED87}" type="presParOf" srcId="{47F6CD61-8625-493D-AAC4-E6F2B2EEE924}" destId="{72EDB95F-2EA1-401F-AF4F-043134B29286}" srcOrd="4" destOrd="0" presId="urn:microsoft.com/office/officeart/2005/8/layout/radial3"/>
    <dgm:cxn modelId="{A4BC6C78-7593-4C6A-B3DF-A26C2E56A649}" type="presParOf" srcId="{47F6CD61-8625-493D-AAC4-E6F2B2EEE924}" destId="{614F53D1-4287-4607-B43A-D85A0FCF661E}" srcOrd="5" destOrd="0" presId="urn:microsoft.com/office/officeart/2005/8/layout/radial3"/>
    <dgm:cxn modelId="{D6243DE6-0475-451E-8B48-179205FFBD45}" type="presParOf" srcId="{47F6CD61-8625-493D-AAC4-E6F2B2EEE924}" destId="{28C80B8C-BF19-4581-9A31-F40D8D8E3B6C}" srcOrd="6" destOrd="0" presId="urn:microsoft.com/office/officeart/2005/8/layout/radial3"/>
    <dgm:cxn modelId="{1674AB56-4983-4012-8061-101E054A8382}" type="presParOf" srcId="{47F6CD61-8625-493D-AAC4-E6F2B2EEE924}" destId="{DE96DFF5-015F-4F59-A3BB-E4577278E7CE}" srcOrd="7" destOrd="0" presId="urn:microsoft.com/office/officeart/2005/8/layout/radial3"/>
    <dgm:cxn modelId="{1125AF07-5A83-441D-8894-4A6E867945B2}" type="presParOf" srcId="{47F6CD61-8625-493D-AAC4-E6F2B2EEE924}" destId="{0D2FAAFB-6C18-4DA1-95E4-D13601D68C8A}" srcOrd="8" destOrd="0" presId="urn:microsoft.com/office/officeart/2005/8/layout/radial3"/>
    <dgm:cxn modelId="{2DA23FAA-1350-49DA-98B6-10BAFA92CAD5}" type="presParOf" srcId="{47F6CD61-8625-493D-AAC4-E6F2B2EEE924}" destId="{CEE8EC5F-8DBF-44DF-8446-C990E41D50F6}" srcOrd="9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9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Rou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nlarged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9CEF480-F38B-426E-BC84-54E4F61CC0CE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1BD2AB-E820-408A-AD8F-A7936B0F510E}" type="par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1F29BDC-E76E-4482-891B-BD4E70E2E1EB}" type="sib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5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5" custScaleX="102126" custRadScaleRad="98691" custRadScaleInc="7574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C5CB0D0-51D5-4107-B5AD-34AD4AEC6DB6}" type="pres">
      <dgm:prSet presAssocID="{79CEF480-F38B-426E-BC84-54E4F61CC0CE}" presName="node" presStyleLbl="vennNode1" presStyleIdx="2" presStyleCnt="5" custScaleX="139447" custRadScaleRad="89254" custRadScaleInc="3537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3" presStyleCnt="5" custScaleX="117356" custRadScaleRad="92126" custRadScaleInc="176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4" presStyleCnt="5" custRadScaleRad="83858" custRadScaleInc="11491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3C865FE0-0523-4AAC-B4A5-A98CD1CA36F3}" type="presOf" srcId="{C72F6624-5DD3-4F43-A003-0ED4444787BB}" destId="{2D3A3C69-23CC-4073-9BB5-7173DB1B5AC6}" srcOrd="0" destOrd="0" presId="urn:microsoft.com/office/officeart/2005/8/layout/radial3"/>
    <dgm:cxn modelId="{2D92E013-DC10-4B57-B64B-EC8E759730CF}" type="presOf" srcId="{0527C542-23FD-4E97-9F9F-A34A08934BE5}" destId="{0D2FAAFB-6C18-4DA1-95E4-D13601D68C8A}" srcOrd="0" destOrd="0" presId="urn:microsoft.com/office/officeart/2005/8/layout/radial3"/>
    <dgm:cxn modelId="{DE2C4248-750A-4A58-9493-B1BB87906778}" srcId="{50C9D290-0252-410F-A1BD-454CF787ADC8}" destId="{0527C542-23FD-4E97-9F9F-A34A08934BE5}" srcOrd="3" destOrd="0" parTransId="{5A7F3E19-4746-495F-AEC8-77E3AB4066C6}" sibTransId="{D0B1DDB7-ED91-4CF5-8E22-D433DAD15D99}"/>
    <dgm:cxn modelId="{604D840B-DD0D-4AFC-893C-54C6E4159DA1}" type="presOf" srcId="{50C9D290-0252-410F-A1BD-454CF787ADC8}" destId="{C7869398-6C49-4AB9-8205-101672020437}" srcOrd="0" destOrd="0" presId="urn:microsoft.com/office/officeart/2005/8/layout/radial3"/>
    <dgm:cxn modelId="{12CED13A-C97B-4EB0-853F-D7CAEC239050}" srcId="{50C9D290-0252-410F-A1BD-454CF787ADC8}" destId="{79CEF480-F38B-426E-BC84-54E4F61CC0CE}" srcOrd="1" destOrd="0" parTransId="{8D1BD2AB-E820-408A-AD8F-A7936B0F510E}" sibTransId="{01F29BDC-E76E-4482-891B-BD4E70E2E1EB}"/>
    <dgm:cxn modelId="{A89ED62D-D68F-4C95-A99B-84526F2591C3}" type="presOf" srcId="{E3F7EF6D-D1CE-43BF-9EED-CCEADA0930F4}" destId="{ADF31E19-3513-45A4-9241-2348A1B01016}" srcOrd="0" destOrd="0" presId="urn:microsoft.com/office/officeart/2005/8/layout/radial3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F01159FF-E81E-49DA-8E1D-D415C5F585FE}" type="presOf" srcId="{A90C8DF0-9A4B-41D3-A6EB-D9A783D586B9}" destId="{8EF7DFA6-5C81-4E45-BE91-EE20E9FAE56A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AA9CF4E8-E06A-452B-ACCA-BD9D057CACA2}" type="presOf" srcId="{79CEF480-F38B-426E-BC84-54E4F61CC0CE}" destId="{7C5CB0D0-51D5-4107-B5AD-34AD4AEC6DB6}" srcOrd="0" destOrd="0" presId="urn:microsoft.com/office/officeart/2005/8/layout/radial3"/>
    <dgm:cxn modelId="{6B30FDDE-89C1-4A42-88DB-0E4BB91426C2}" srcId="{50C9D290-0252-410F-A1BD-454CF787ADC8}" destId="{E3F7EF6D-D1CE-43BF-9EED-CCEADA0930F4}" srcOrd="2" destOrd="0" parTransId="{A8EC8D59-92BD-4DB8-B755-C2D0942606BB}" sibTransId="{6DF65815-CAEA-498B-A0ED-E0A39EA33A85}"/>
    <dgm:cxn modelId="{CDAD6C50-A9E2-4FC7-8E46-900F11DB1C40}" type="presParOf" srcId="{2D3A3C69-23CC-4073-9BB5-7173DB1B5AC6}" destId="{47F6CD61-8625-493D-AAC4-E6F2B2EEE924}" srcOrd="0" destOrd="0" presId="urn:microsoft.com/office/officeart/2005/8/layout/radial3"/>
    <dgm:cxn modelId="{564DC36E-068F-4711-8CF6-971EF452348E}" type="presParOf" srcId="{47F6CD61-8625-493D-AAC4-E6F2B2EEE924}" destId="{C7869398-6C49-4AB9-8205-101672020437}" srcOrd="0" destOrd="0" presId="urn:microsoft.com/office/officeart/2005/8/layout/radial3"/>
    <dgm:cxn modelId="{73CA9EC0-2051-49FC-816B-81CEA847174B}" type="presParOf" srcId="{47F6CD61-8625-493D-AAC4-E6F2B2EEE924}" destId="{8EF7DFA6-5C81-4E45-BE91-EE20E9FAE56A}" srcOrd="1" destOrd="0" presId="urn:microsoft.com/office/officeart/2005/8/layout/radial3"/>
    <dgm:cxn modelId="{1AFC50B4-59C6-4571-97FD-5CEFA8C3E324}" type="presParOf" srcId="{47F6CD61-8625-493D-AAC4-E6F2B2EEE924}" destId="{7C5CB0D0-51D5-4107-B5AD-34AD4AEC6DB6}" srcOrd="2" destOrd="0" presId="urn:microsoft.com/office/officeart/2005/8/layout/radial3"/>
    <dgm:cxn modelId="{76763C0A-E741-4C35-9BF5-9481E4672430}" type="presParOf" srcId="{47F6CD61-8625-493D-AAC4-E6F2B2EEE924}" destId="{ADF31E19-3513-45A4-9241-2348A1B01016}" srcOrd="3" destOrd="0" presId="urn:microsoft.com/office/officeart/2005/8/layout/radial3"/>
    <dgm:cxn modelId="{195B0AA4-9F0B-4566-B2AD-BC598926F62E}" type="presParOf" srcId="{47F6CD61-8625-493D-AAC4-E6F2B2EEE924}" destId="{0D2FAAFB-6C18-4DA1-95E4-D13601D68C8A}" srcOrd="4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interact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with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 the </a:t>
          </a:r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environment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1285A5-BDA8-4319-9B18-A272AE807501}">
      <dgm:prSet phldrT="[Texto]" custT="1"/>
      <dgm:spPr/>
      <dgm:t>
        <a:bodyPr/>
        <a:lstStyle/>
        <a:p>
          <a:r>
            <a:rPr lang="es-ES" sz="700" dirty="0" err="1" smtClean="0"/>
            <a:t>Difficult</a:t>
          </a:r>
          <a:r>
            <a:rPr lang="es-ES" sz="900" dirty="0" smtClean="0"/>
            <a:t> to </a:t>
          </a:r>
          <a:r>
            <a:rPr lang="es-ES" sz="900" dirty="0" err="1" smtClean="0"/>
            <a:t>feed</a:t>
          </a:r>
          <a:endParaRPr lang="es-ES" sz="9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C83CB-467D-45AD-848C-3AFEDEE37424}" type="par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C9E6D4-16C4-41BD-964C-0D4FE940A841}" type="sib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F307E38-E9EA-48C7-BB5D-7186A49E7AB2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752D029-C0D8-438D-BDDF-ADBDBB5D708A}" type="par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385C5A4-42F9-4644-9246-1AF9FC506284}" type="sibTrans" cxnId="{B3C6C3F4-339C-44C2-B325-F6CCAE3FDDF9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Larynx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piglotti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6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F58F62-2558-46D7-A230-720F7B055378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ar</a:t>
          </a:r>
          <a:endParaRPr lang="es-ES" sz="700" dirty="0" smtClean="0"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6718D0-449E-496D-8D69-A4AC9344CE34}" type="par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8D8F35-9B11-49D3-8837-BDCBC81252A7}" type="sibTrans" cxnId="{1B83F487-009E-4022-97A4-F5F23B18BA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/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/>
        </a:p>
      </dgm:t>
    </dgm:pt>
    <dgm:pt modelId="{D655FC61-77AB-474C-87EC-65CEF9F0AFE0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0FDC6B-04CF-4EB8-BD67-90C9D623F3AF}" type="parTrans" cxnId="{F9916CE0-7462-417D-BB07-48411A2AB4D1}">
      <dgm:prSet/>
      <dgm:spPr/>
      <dgm:t>
        <a:bodyPr/>
        <a:lstStyle/>
        <a:p>
          <a:endParaRPr lang="es-ES"/>
        </a:p>
      </dgm:t>
    </dgm:pt>
    <dgm:pt modelId="{4B18C9CE-79C0-4C3C-BB08-DA387AFD666C}" type="sibTrans" cxnId="{F9916CE0-7462-417D-BB07-48411A2AB4D1}">
      <dgm:prSet/>
      <dgm:spPr/>
      <dgm:t>
        <a:bodyPr/>
        <a:lstStyle/>
        <a:p>
          <a:endParaRPr lang="es-ES"/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/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/>
        </a:p>
      </dgm:t>
    </dgm:pt>
    <dgm:pt modelId="{FC7903FA-6757-49A7-9625-6E4B010FEF03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F767A8-458F-48C0-B779-475106FA88B7}" type="parTrans" cxnId="{F1DFCA33-F551-4F55-960D-C7C29DD0C83B}">
      <dgm:prSet/>
      <dgm:spPr/>
      <dgm:t>
        <a:bodyPr/>
        <a:lstStyle/>
        <a:p>
          <a:endParaRPr lang="es-ES"/>
        </a:p>
      </dgm:t>
    </dgm:pt>
    <dgm:pt modelId="{5915D032-3986-42FD-BC78-4F708CC457CB}" type="sibTrans" cxnId="{F1DFCA33-F551-4F55-960D-C7C29DD0C83B}">
      <dgm:prSet/>
      <dgm:spPr/>
      <dgm:t>
        <a:bodyPr/>
        <a:lstStyle/>
        <a:p>
          <a:endParaRPr lang="es-ES"/>
        </a:p>
      </dgm:t>
    </dgm:pt>
    <dgm:pt modelId="{26D285B8-9EDF-447E-BA53-0BD8F843D12A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Join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dislocation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D972436-8F18-4E3C-AB70-9D1CBAE0C40C}" type="parTrans" cxnId="{CAF57F0E-B4B1-4A1C-A844-515A224D935D}">
      <dgm:prSet/>
      <dgm:spPr/>
      <dgm:t>
        <a:bodyPr/>
        <a:lstStyle/>
        <a:p>
          <a:endParaRPr lang="es-ES"/>
        </a:p>
      </dgm:t>
    </dgm:pt>
    <dgm:pt modelId="{03885B23-4511-4AC2-99C7-9336D9393914}" type="sibTrans" cxnId="{CAF57F0E-B4B1-4A1C-A844-515A224D935D}">
      <dgm:prSet/>
      <dgm:spPr/>
      <dgm:t>
        <a:bodyPr/>
        <a:lstStyle/>
        <a:p>
          <a:endParaRPr lang="es-ES"/>
        </a:p>
      </dgm:t>
    </dgm:pt>
    <dgm:pt modelId="{4790DFA0-B779-4120-BBB9-B3A0788BCCA7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2073E94-8594-47D1-A7BB-F4E365DF93B9}" type="parTrans" cxnId="{216D287F-0F37-4F37-81E5-4313043FE258}">
      <dgm:prSet/>
      <dgm:spPr/>
      <dgm:t>
        <a:bodyPr/>
        <a:lstStyle/>
        <a:p>
          <a:endParaRPr lang="es-ES"/>
        </a:p>
      </dgm:t>
    </dgm:pt>
    <dgm:pt modelId="{1EBA678E-B1DE-448F-8169-8093F077F791}" type="sibTrans" cxnId="{216D287F-0F37-4F37-81E5-4313043FE258}">
      <dgm:prSet/>
      <dgm:spPr/>
      <dgm:t>
        <a:bodyPr/>
        <a:lstStyle/>
        <a:p>
          <a:endParaRPr lang="es-ES"/>
        </a:p>
      </dgm:t>
    </dgm:pt>
    <dgm:pt modelId="{D4AA1C64-B710-48C1-9EEE-FCAFB3746B96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amily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member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no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longer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work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for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ar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AEA218B-8D9F-453D-A9AF-8A7B86FB58C8}" type="parTrans" cxnId="{7420239E-0997-48DE-A4FB-228250C93783}">
      <dgm:prSet/>
      <dgm:spPr/>
      <dgm:t>
        <a:bodyPr/>
        <a:lstStyle/>
        <a:p>
          <a:endParaRPr lang="es-ES"/>
        </a:p>
      </dgm:t>
    </dgm:pt>
    <dgm:pt modelId="{CF73AB3D-A726-48A0-80D5-43098C9F5FE4}" type="sibTrans" cxnId="{7420239E-0997-48DE-A4FB-228250C93783}">
      <dgm:prSet/>
      <dgm:spPr/>
      <dgm:t>
        <a:bodyPr/>
        <a:lstStyle/>
        <a:p>
          <a:endParaRPr lang="es-ES"/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14" custScaleX="132605" custScaleY="116562" custLinFactNeighborX="3646" custLinFactNeighborY="6877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14" custScaleX="166407" custRadScaleRad="82459" custRadScaleInc="-329917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9770CDF7-8417-4BBA-9FBC-F8390177E143}" type="pres">
      <dgm:prSet presAssocID="{FC7903FA-6757-49A7-9625-6E4B010FEF03}" presName="node" presStyleLbl="vennNode1" presStyleIdx="2" presStyleCnt="14" custScaleX="134800" custRadScaleRad="85245" custRadScaleInc="-32288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8262EBD1-2017-484A-9727-5BB0DEA45C1E}" type="pres">
      <dgm:prSet presAssocID="{1A1285A5-BDA8-4319-9B18-A272AE807501}" presName="node" presStyleLbl="vennNode1" presStyleIdx="3" presStyleCnt="14" custScaleX="117356" custRadScaleRad="85589" custRadScaleInc="-24215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4" presStyleCnt="14" custScaleX="117356" custRadScaleRad="88010" custRadScaleInc="-11290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2EDB95F-2EA1-401F-AF4F-043134B29286}" type="pres">
      <dgm:prSet presAssocID="{FF307E38-E9EA-48C7-BB5D-7186A49E7AB2}" presName="node" presStyleLbl="vennNode1" presStyleIdx="5" presStyleCnt="14" custScaleX="141878" custRadScaleRad="113880" custRadScaleInc="2805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6" presStyleCnt="14" custRadScaleRad="107748" custRadScaleInc="29757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28C80B8C-BF19-4581-9A31-F40D8D8E3B6C}" type="pres">
      <dgm:prSet presAssocID="{D655FC61-77AB-474C-87EC-65CEF9F0AFE0}" presName="node" presStyleLbl="vennNode1" presStyleIdx="7" presStyleCnt="14" custScaleX="143445" custRadScaleRad="98415" custRadScaleInc="27932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8" presStyleCnt="14" custScaleX="127006" custRadScaleRad="109790" custRadScaleInc="4415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9" presStyleCnt="14" custScaleX="170357" custRadScaleRad="118085" custRadScaleInc="6769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CEE8EC5F-8DBF-44DF-8446-C990E41D50F6}" type="pres">
      <dgm:prSet presAssocID="{29F58F62-2558-46D7-A230-720F7B055378}" presName="node" presStyleLbl="vennNode1" presStyleIdx="10" presStyleCnt="14" custScaleX="143181" custRadScaleRad="106539" custRadScaleInc="23499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54FA25BC-2D34-48BC-89C3-CEA2C1AB809D}" type="pres">
      <dgm:prSet presAssocID="{26D285B8-9EDF-447E-BA53-0BD8F843D12A}" presName="node" presStyleLbl="vennNode1" presStyleIdx="11" presStyleCnt="14" custScaleX="140273" custRadScaleRad="110809" custRadScaleInc="37744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1038236E-81C7-4FE6-9BD5-0602F9F4F3AE}" type="pres">
      <dgm:prSet presAssocID="{4790DFA0-B779-4120-BBB9-B3A0788BCCA7}" presName="node" presStyleLbl="vennNode1" presStyleIdx="12" presStyleCnt="14" custScaleX="140366" custRadScaleRad="134618" custRadScaleInc="46195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92DD552-EE5E-480B-8C78-9BEF90C23308}" type="pres">
      <dgm:prSet presAssocID="{D4AA1C64-B710-48C1-9EEE-FCAFB3746B96}" presName="node" presStyleLbl="vennNode1" presStyleIdx="13" presStyleCnt="14" custScaleX="169624" custRadScaleRad="108249" custRadScaleInc="42042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22607796-E1A7-4990-823C-9AC53A2EEE55}" type="presOf" srcId="{50C9D290-0252-410F-A1BD-454CF787ADC8}" destId="{C7869398-6C49-4AB9-8205-101672020437}" srcOrd="0" destOrd="0" presId="urn:microsoft.com/office/officeart/2005/8/layout/radial3"/>
    <dgm:cxn modelId="{B2D6C6BE-D463-4BB8-97F8-3E71C96A0F65}" type="presOf" srcId="{1A1285A5-BDA8-4319-9B18-A272AE807501}" destId="{8262EBD1-2017-484A-9727-5BB0DEA45C1E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F9916CE0-7462-417D-BB07-48411A2AB4D1}" srcId="{50C9D290-0252-410F-A1BD-454CF787ADC8}" destId="{D655FC61-77AB-474C-87EC-65CEF9F0AFE0}" srcOrd="6" destOrd="0" parTransId="{080FDC6B-04CF-4EB8-BD67-90C9D623F3AF}" sibTransId="{4B18C9CE-79C0-4C3C-BB08-DA387AFD666C}"/>
    <dgm:cxn modelId="{B3C6C3F4-339C-44C2-B325-F6CCAE3FDDF9}" srcId="{50C9D290-0252-410F-A1BD-454CF787ADC8}" destId="{FF307E38-E9EA-48C7-BB5D-7186A49E7AB2}" srcOrd="4" destOrd="0" parTransId="{E752D029-C0D8-438D-BDDF-ADBDBB5D708A}" sibTransId="{B385C5A4-42F9-4644-9246-1AF9FC506284}"/>
    <dgm:cxn modelId="{7C52A876-6248-4650-90E3-D50FC1908B5B}" srcId="{50C9D290-0252-410F-A1BD-454CF787ADC8}" destId="{B46FB715-7AFC-451B-9469-DD324419BDC1}" srcOrd="7" destOrd="0" parTransId="{E0CE2B5E-4E85-46A0-8B69-7163AB1BDCA6}" sibTransId="{BC5E5B88-F594-4024-99F1-EA04404C6DF2}"/>
    <dgm:cxn modelId="{DC35FD01-4805-4CFB-910D-5EF002955A52}" type="presOf" srcId="{0527C542-23FD-4E97-9F9F-A34A08934BE5}" destId="{0D2FAAFB-6C18-4DA1-95E4-D13601D68C8A}" srcOrd="0" destOrd="0" presId="urn:microsoft.com/office/officeart/2005/8/layout/radial3"/>
    <dgm:cxn modelId="{DE2C4248-750A-4A58-9493-B1BB87906778}" srcId="{50C9D290-0252-410F-A1BD-454CF787ADC8}" destId="{0527C542-23FD-4E97-9F9F-A34A08934BE5}" srcOrd="8" destOrd="0" parTransId="{5A7F3E19-4746-495F-AEC8-77E3AB4066C6}" sibTransId="{D0B1DDB7-ED91-4CF5-8E22-D433DAD15D99}"/>
    <dgm:cxn modelId="{21C585AA-3FE0-4883-8365-52F7DB5F0B3C}" type="presOf" srcId="{FC7903FA-6757-49A7-9625-6E4B010FEF03}" destId="{9770CDF7-8417-4BBA-9FBC-F8390177E143}" srcOrd="0" destOrd="0" presId="urn:microsoft.com/office/officeart/2005/8/layout/radial3"/>
    <dgm:cxn modelId="{1B83F487-009E-4022-97A4-F5F23B18BABB}" srcId="{50C9D290-0252-410F-A1BD-454CF787ADC8}" destId="{29F58F62-2558-46D7-A230-720F7B055378}" srcOrd="9" destOrd="0" parTransId="{386718D0-449E-496D-8D69-A4AC9344CE34}" sibTransId="{2E8D8F35-9B11-49D3-8837-BDCBC81252A7}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8F9D150A-DEC2-42D7-B4E8-DD2FAE90B288}" type="presOf" srcId="{D6F84C29-B6D5-4E7D-BDD6-569F8EC9E27C}" destId="{614F53D1-4287-4607-B43A-D85A0FCF661E}" srcOrd="0" destOrd="0" presId="urn:microsoft.com/office/officeart/2005/8/layout/radial3"/>
    <dgm:cxn modelId="{F1DFCA33-F551-4F55-960D-C7C29DD0C83B}" srcId="{50C9D290-0252-410F-A1BD-454CF787ADC8}" destId="{FC7903FA-6757-49A7-9625-6E4B010FEF03}" srcOrd="1" destOrd="0" parTransId="{B8F767A8-458F-48C0-B779-475106FA88B7}" sibTransId="{5915D032-3986-42FD-BC78-4F708CC457CB}"/>
    <dgm:cxn modelId="{DE5985C2-8541-44B6-9C89-F90CA00975F3}" type="presOf" srcId="{B46FB715-7AFC-451B-9469-DD324419BDC1}" destId="{DE96DFF5-015F-4F59-A3BB-E4577278E7CE}" srcOrd="0" destOrd="0" presId="urn:microsoft.com/office/officeart/2005/8/layout/radial3"/>
    <dgm:cxn modelId="{CAF57F0E-B4B1-4A1C-A844-515A224D935D}" srcId="{50C9D290-0252-410F-A1BD-454CF787ADC8}" destId="{26D285B8-9EDF-447E-BA53-0BD8F843D12A}" srcOrd="10" destOrd="0" parTransId="{5D972436-8F18-4E3C-AB70-9D1CBAE0C40C}" sibTransId="{03885B23-4511-4AC2-99C7-9336D9393914}"/>
    <dgm:cxn modelId="{7420239E-0997-48DE-A4FB-228250C93783}" srcId="{50C9D290-0252-410F-A1BD-454CF787ADC8}" destId="{D4AA1C64-B710-48C1-9EEE-FCAFB3746B96}" srcOrd="12" destOrd="0" parTransId="{DAEA218B-8D9F-453D-A9AF-8A7B86FB58C8}" sibTransId="{CF73AB3D-A726-48A0-80D5-43098C9F5FE4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216D287F-0F37-4F37-81E5-4313043FE258}" srcId="{50C9D290-0252-410F-A1BD-454CF787ADC8}" destId="{4790DFA0-B779-4120-BBB9-B3A0788BCCA7}" srcOrd="11" destOrd="0" parTransId="{02073E94-8594-47D1-A7BB-F4E365DF93B9}" sibTransId="{1EBA678E-B1DE-448F-8169-8093F077F791}"/>
    <dgm:cxn modelId="{C6DD66C3-E0B4-4B65-85D9-0D401A88D115}" type="presOf" srcId="{D4AA1C64-B710-48C1-9EEE-FCAFB3746B96}" destId="{A92DD552-EE5E-480B-8C78-9BEF90C23308}" srcOrd="0" destOrd="0" presId="urn:microsoft.com/office/officeart/2005/8/layout/radial3"/>
    <dgm:cxn modelId="{BB8B25FE-B0FB-47C6-911B-41A217D9ECE3}" type="presOf" srcId="{D655FC61-77AB-474C-87EC-65CEF9F0AFE0}" destId="{28C80B8C-BF19-4581-9A31-F40D8D8E3B6C}" srcOrd="0" destOrd="0" presId="urn:microsoft.com/office/officeart/2005/8/layout/radial3"/>
    <dgm:cxn modelId="{EE6CB282-B507-4FD3-95DB-2391B84DAB5A}" type="presOf" srcId="{4790DFA0-B779-4120-BBB9-B3A0788BCCA7}" destId="{1038236E-81C7-4FE6-9BD5-0602F9F4F3AE}" srcOrd="0" destOrd="0" presId="urn:microsoft.com/office/officeart/2005/8/layout/radial3"/>
    <dgm:cxn modelId="{01BB55F4-B42B-4DF8-AEA1-01EA77AA7B85}" type="presOf" srcId="{29F58F62-2558-46D7-A230-720F7B055378}" destId="{CEE8EC5F-8DBF-44DF-8446-C990E41D50F6}" srcOrd="0" destOrd="0" presId="urn:microsoft.com/office/officeart/2005/8/layout/radial3"/>
    <dgm:cxn modelId="{3ABEBAFF-8BAA-464B-8679-9A9439F950F0}" type="presOf" srcId="{E3F7EF6D-D1CE-43BF-9EED-CCEADA0930F4}" destId="{ADF31E19-3513-45A4-9241-2348A1B01016}" srcOrd="0" destOrd="0" presId="urn:microsoft.com/office/officeart/2005/8/layout/radial3"/>
    <dgm:cxn modelId="{4DB67F51-6DAD-4DBD-A835-6897771B7114}" type="presOf" srcId="{A90C8DF0-9A4B-41D3-A6EB-D9A783D586B9}" destId="{8EF7DFA6-5C81-4E45-BE91-EE20E9FAE56A}" srcOrd="0" destOrd="0" presId="urn:microsoft.com/office/officeart/2005/8/layout/radial3"/>
    <dgm:cxn modelId="{BE0B8567-C12B-4C73-959A-0148BA7384C6}" type="presOf" srcId="{26D285B8-9EDF-447E-BA53-0BD8F843D12A}" destId="{54FA25BC-2D34-48BC-89C3-CEA2C1AB809D}" srcOrd="0" destOrd="0" presId="urn:microsoft.com/office/officeart/2005/8/layout/radial3"/>
    <dgm:cxn modelId="{6B30FDDE-89C1-4A42-88DB-0E4BB91426C2}" srcId="{50C9D290-0252-410F-A1BD-454CF787ADC8}" destId="{E3F7EF6D-D1CE-43BF-9EED-CCEADA0930F4}" srcOrd="3" destOrd="0" parTransId="{A8EC8D59-92BD-4DB8-B755-C2D0942606BB}" sibTransId="{6DF65815-CAEA-498B-A0ED-E0A39EA33A85}"/>
    <dgm:cxn modelId="{C2579A1B-878B-489B-93BE-2FF3DEFD4A3A}" type="presOf" srcId="{C72F6624-5DD3-4F43-A003-0ED4444787BB}" destId="{2D3A3C69-23CC-4073-9BB5-7173DB1B5AC6}" srcOrd="0" destOrd="0" presId="urn:microsoft.com/office/officeart/2005/8/layout/radial3"/>
    <dgm:cxn modelId="{B6750CD8-014E-443D-92FE-E3E23E4B21BA}" srcId="{50C9D290-0252-410F-A1BD-454CF787ADC8}" destId="{1A1285A5-BDA8-4319-9B18-A272AE807501}" srcOrd="2" destOrd="0" parTransId="{E26C83CB-467D-45AD-848C-3AFEDEE37424}" sibTransId="{A9C9E6D4-16C4-41BD-964C-0D4FE940A841}"/>
    <dgm:cxn modelId="{4FB4442C-5614-4E26-A1E8-CBE28EF8FFBB}" srcId="{50C9D290-0252-410F-A1BD-454CF787ADC8}" destId="{D6F84C29-B6D5-4E7D-BDD6-569F8EC9E27C}" srcOrd="5" destOrd="0" parTransId="{50857628-DD61-4A89-861A-FD844547EBD0}" sibTransId="{903494E9-1B93-4790-87F7-6187FC54F61D}"/>
    <dgm:cxn modelId="{62DAA7FD-16E0-4F2B-B706-39DF7BEBAC10}" type="presOf" srcId="{FF307E38-E9EA-48C7-BB5D-7186A49E7AB2}" destId="{72EDB95F-2EA1-401F-AF4F-043134B29286}" srcOrd="0" destOrd="0" presId="urn:microsoft.com/office/officeart/2005/8/layout/radial3"/>
    <dgm:cxn modelId="{97A5C3C4-191F-46BC-B4BC-07A0779A6889}" type="presParOf" srcId="{2D3A3C69-23CC-4073-9BB5-7173DB1B5AC6}" destId="{47F6CD61-8625-493D-AAC4-E6F2B2EEE924}" srcOrd="0" destOrd="0" presId="urn:microsoft.com/office/officeart/2005/8/layout/radial3"/>
    <dgm:cxn modelId="{65396139-F17D-4BB0-978F-D101F5EA1E9B}" type="presParOf" srcId="{47F6CD61-8625-493D-AAC4-E6F2B2EEE924}" destId="{C7869398-6C49-4AB9-8205-101672020437}" srcOrd="0" destOrd="0" presId="urn:microsoft.com/office/officeart/2005/8/layout/radial3"/>
    <dgm:cxn modelId="{AE9D2C35-B204-435A-BEC8-790D36EDAEAA}" type="presParOf" srcId="{47F6CD61-8625-493D-AAC4-E6F2B2EEE924}" destId="{8EF7DFA6-5C81-4E45-BE91-EE20E9FAE56A}" srcOrd="1" destOrd="0" presId="urn:microsoft.com/office/officeart/2005/8/layout/radial3"/>
    <dgm:cxn modelId="{1203E488-7876-4A4B-BCD2-17CDB75835DF}" type="presParOf" srcId="{47F6CD61-8625-493D-AAC4-E6F2B2EEE924}" destId="{9770CDF7-8417-4BBA-9FBC-F8390177E143}" srcOrd="2" destOrd="0" presId="urn:microsoft.com/office/officeart/2005/8/layout/radial3"/>
    <dgm:cxn modelId="{29724CFF-C28C-43FC-BE22-A2497333E767}" type="presParOf" srcId="{47F6CD61-8625-493D-AAC4-E6F2B2EEE924}" destId="{8262EBD1-2017-484A-9727-5BB0DEA45C1E}" srcOrd="3" destOrd="0" presId="urn:microsoft.com/office/officeart/2005/8/layout/radial3"/>
    <dgm:cxn modelId="{57454A29-B284-40FF-8209-144A2362382F}" type="presParOf" srcId="{47F6CD61-8625-493D-AAC4-E6F2B2EEE924}" destId="{ADF31E19-3513-45A4-9241-2348A1B01016}" srcOrd="4" destOrd="0" presId="urn:microsoft.com/office/officeart/2005/8/layout/radial3"/>
    <dgm:cxn modelId="{16FAAC21-A618-476D-AD62-DCC7593A637C}" type="presParOf" srcId="{47F6CD61-8625-493D-AAC4-E6F2B2EEE924}" destId="{72EDB95F-2EA1-401F-AF4F-043134B29286}" srcOrd="5" destOrd="0" presId="urn:microsoft.com/office/officeart/2005/8/layout/radial3"/>
    <dgm:cxn modelId="{F7796771-F79D-4E46-8FFF-80B2AE9A35B4}" type="presParOf" srcId="{47F6CD61-8625-493D-AAC4-E6F2B2EEE924}" destId="{614F53D1-4287-4607-B43A-D85A0FCF661E}" srcOrd="6" destOrd="0" presId="urn:microsoft.com/office/officeart/2005/8/layout/radial3"/>
    <dgm:cxn modelId="{E94BFCEC-2BE5-46FB-94AC-53E6552241DC}" type="presParOf" srcId="{47F6CD61-8625-493D-AAC4-E6F2B2EEE924}" destId="{28C80B8C-BF19-4581-9A31-F40D8D8E3B6C}" srcOrd="7" destOrd="0" presId="urn:microsoft.com/office/officeart/2005/8/layout/radial3"/>
    <dgm:cxn modelId="{B9DFD440-4F49-4DC3-9C4E-2D63ECFB4201}" type="presParOf" srcId="{47F6CD61-8625-493D-AAC4-E6F2B2EEE924}" destId="{DE96DFF5-015F-4F59-A3BB-E4577278E7CE}" srcOrd="8" destOrd="0" presId="urn:microsoft.com/office/officeart/2005/8/layout/radial3"/>
    <dgm:cxn modelId="{774AD295-F377-467F-B646-92656F645D45}" type="presParOf" srcId="{47F6CD61-8625-493D-AAC4-E6F2B2EEE924}" destId="{0D2FAAFB-6C18-4DA1-95E4-D13601D68C8A}" srcOrd="9" destOrd="0" presId="urn:microsoft.com/office/officeart/2005/8/layout/radial3"/>
    <dgm:cxn modelId="{D2AF613F-4D08-4EA0-91ED-D591F1845CCC}" type="presParOf" srcId="{47F6CD61-8625-493D-AAC4-E6F2B2EEE924}" destId="{CEE8EC5F-8DBF-44DF-8446-C990E41D50F6}" srcOrd="10" destOrd="0" presId="urn:microsoft.com/office/officeart/2005/8/layout/radial3"/>
    <dgm:cxn modelId="{00F6654C-E82D-49EA-B3AB-710AD54FB005}" type="presParOf" srcId="{47F6CD61-8625-493D-AAC4-E6F2B2EEE924}" destId="{54FA25BC-2D34-48BC-89C3-CEA2C1AB809D}" srcOrd="11" destOrd="0" presId="urn:microsoft.com/office/officeart/2005/8/layout/radial3"/>
    <dgm:cxn modelId="{5C38EE31-04EF-4CCD-8011-DB6A55A8249C}" type="presParOf" srcId="{47F6CD61-8625-493D-AAC4-E6F2B2EEE924}" destId="{1038236E-81C7-4FE6-9BD5-0602F9F4F3AE}" srcOrd="12" destOrd="0" presId="urn:microsoft.com/office/officeart/2005/8/layout/radial3"/>
    <dgm:cxn modelId="{6F756398-50A2-46AA-BDCA-6DCC6F60E68E}" type="presParOf" srcId="{47F6CD61-8625-493D-AAC4-E6F2B2EEE924}" destId="{A92DD552-EE5E-480B-8C78-9BEF90C23308}" srcOrd="13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21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1285A5-BDA8-4319-9B18-A272AE807501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Diffiul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to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eed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C83CB-467D-45AD-848C-3AFEDEE37424}" type="parTrans" cxnId="{B6750CD8-014E-443D-92FE-E3E23E4B21BA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C9E6D4-16C4-41BD-964C-0D4FE940A841}" type="sibTrans" cxnId="{B6750CD8-014E-443D-92FE-E3E23E4B21BA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F307E38-E9EA-48C7-BB5D-7186A49E7AB2}">
      <dgm:prSet phldrT="[Texto]" custT="1"/>
      <dgm:spPr/>
      <dgm:t>
        <a:bodyPr/>
        <a:lstStyle/>
        <a:p>
          <a:r>
            <a:rPr lang="es-ES" sz="6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600" dirty="0" smtClean="0">
              <a:latin typeface="Arial" panose="020B0604020202020204" pitchFamily="34" charset="0"/>
              <a:cs typeface="Arial" panose="020B0604020202020204" pitchFamily="34" charset="0"/>
            </a:rPr>
            <a:t> to be </a:t>
          </a:r>
          <a:r>
            <a:rPr lang="es-ES" sz="600" dirty="0" err="1" smtClean="0">
              <a:latin typeface="Arial" panose="020B0604020202020204" pitchFamily="34" charset="0"/>
              <a:cs typeface="Arial" panose="020B0604020202020204" pitchFamily="34" charset="0"/>
            </a:rPr>
            <a:t>seated</a:t>
          </a:r>
          <a:r>
            <a:rPr lang="es-ES" sz="6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6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6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752D029-C0D8-438D-BDDF-ADBDBB5D708A}" type="parTrans" cxnId="{B3C6C3F4-339C-44C2-B325-F6CCAE3FDDF9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385C5A4-42F9-4644-9246-1AF9FC506284}" type="sibTrans" cxnId="{B3C6C3F4-339C-44C2-B325-F6CCAE3FDDF9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Use of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ernative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ommun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.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tool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Larynx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piglotti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Dental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F58F62-2558-46D7-A230-720F7B055378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6718D0-449E-496D-8D69-A4AC9344CE34}" type="parTrans" cxnId="{1B83F487-009E-4022-97A4-F5F23B18BAB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8D8F35-9B11-49D3-8837-BDCBC81252A7}" type="sibTrans" cxnId="{1B83F487-009E-4022-97A4-F5F23B18BABB}">
      <dgm:prSet/>
      <dgm:spPr/>
      <dgm:t>
        <a:bodyPr/>
        <a:lstStyle/>
        <a:p>
          <a:endParaRPr lang="es-ES" sz="1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55FC61-77AB-474C-87EC-65CEF9F0AFE0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0FDC6B-04CF-4EB8-BD67-90C9D623F3AF}" type="parTrans" cxnId="{F9916CE0-7462-417D-BB07-48411A2AB4D1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B18C9CE-79C0-4C3C-BB08-DA387AFD666C}" type="sibTrans" cxnId="{F9916CE0-7462-417D-BB07-48411A2AB4D1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10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10" custScaleX="125255" custRadScaleRad="105630" custRadScaleInc="-12007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8262EBD1-2017-484A-9727-5BB0DEA45C1E}" type="pres">
      <dgm:prSet presAssocID="{1A1285A5-BDA8-4319-9B18-A272AE807501}" presName="node" presStyleLbl="vennNode1" presStyleIdx="2" presStyleCnt="10" custScaleX="117356" custRadScaleRad="106564" custRadScaleInc="-138876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3" presStyleCnt="10" custScaleX="117356" custRadScaleRad="107319" custRadScaleInc="-13275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2EDB95F-2EA1-401F-AF4F-043134B29286}" type="pres">
      <dgm:prSet presAssocID="{FF307E38-E9EA-48C7-BB5D-7186A49E7AB2}" presName="node" presStyleLbl="vennNode1" presStyleIdx="4" presStyleCnt="10" custRadScaleRad="96005" custRadScaleInc="-1089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5" presStyleCnt="10" custScaleX="123744" custRadScaleRad="103407" custRadScaleInc="-642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28C80B8C-BF19-4581-9A31-F40D8D8E3B6C}" type="pres">
      <dgm:prSet presAssocID="{D655FC61-77AB-474C-87EC-65CEF9F0AFE0}" presName="node" presStyleLbl="vennNode1" presStyleIdx="6" presStyleCnt="10" custScaleX="11700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7" presStyleCnt="10" custScaleX="104227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8" presStyleCnt="10" custScaleX="126850" custRadScaleRad="107478" custRadScaleInc="162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CEE8EC5F-8DBF-44DF-8446-C990E41D50F6}" type="pres">
      <dgm:prSet presAssocID="{29F58F62-2558-46D7-A230-720F7B055378}" presName="node" presStyleLbl="vennNode1" presStyleIdx="9" presStyleCnt="10" custRadScaleRad="94809" custRadScaleInc="27216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225FC196-E884-4B39-9A49-CC7AA0CFA4FA}" type="presOf" srcId="{C72F6624-5DD3-4F43-A003-0ED4444787BB}" destId="{2D3A3C69-23CC-4073-9BB5-7173DB1B5AC6}" srcOrd="0" destOrd="0" presId="urn:microsoft.com/office/officeart/2005/8/layout/radial3"/>
    <dgm:cxn modelId="{339CCAF4-6729-48C0-B239-79DD067AD0EF}" type="presOf" srcId="{0527C542-23FD-4E97-9F9F-A34A08934BE5}" destId="{0D2FAAFB-6C18-4DA1-95E4-D13601D68C8A}" srcOrd="0" destOrd="0" presId="urn:microsoft.com/office/officeart/2005/8/layout/radial3"/>
    <dgm:cxn modelId="{F9916CE0-7462-417D-BB07-48411A2AB4D1}" srcId="{50C9D290-0252-410F-A1BD-454CF787ADC8}" destId="{D655FC61-77AB-474C-87EC-65CEF9F0AFE0}" srcOrd="5" destOrd="0" parTransId="{080FDC6B-04CF-4EB8-BD67-90C9D623F3AF}" sibTransId="{4B18C9CE-79C0-4C3C-BB08-DA387AFD666C}"/>
    <dgm:cxn modelId="{DE2C4248-750A-4A58-9493-B1BB87906778}" srcId="{50C9D290-0252-410F-A1BD-454CF787ADC8}" destId="{0527C542-23FD-4E97-9F9F-A34A08934BE5}" srcOrd="7" destOrd="0" parTransId="{5A7F3E19-4746-495F-AEC8-77E3AB4066C6}" sibTransId="{D0B1DDB7-ED91-4CF5-8E22-D433DAD15D99}"/>
    <dgm:cxn modelId="{4A5545C1-A53A-45F6-8D94-0AFFD149E8D8}" type="presOf" srcId="{D655FC61-77AB-474C-87EC-65CEF9F0AFE0}" destId="{28C80B8C-BF19-4581-9A31-F40D8D8E3B6C}" srcOrd="0" destOrd="0" presId="urn:microsoft.com/office/officeart/2005/8/layout/radial3"/>
    <dgm:cxn modelId="{997CD0AD-FD65-413B-BAA1-52AC11085654}" type="presOf" srcId="{A90C8DF0-9A4B-41D3-A6EB-D9A783D586B9}" destId="{8EF7DFA6-5C81-4E45-BE91-EE20E9FAE56A}" srcOrd="0" destOrd="0" presId="urn:microsoft.com/office/officeart/2005/8/layout/radial3"/>
    <dgm:cxn modelId="{7C52A876-6248-4650-90E3-D50FC1908B5B}" srcId="{50C9D290-0252-410F-A1BD-454CF787ADC8}" destId="{B46FB715-7AFC-451B-9469-DD324419BDC1}" srcOrd="6" destOrd="0" parTransId="{E0CE2B5E-4E85-46A0-8B69-7163AB1BDCA6}" sibTransId="{BC5E5B88-F594-4024-99F1-EA04404C6DF2}"/>
    <dgm:cxn modelId="{B6750CD8-014E-443D-92FE-E3E23E4B21BA}" srcId="{50C9D290-0252-410F-A1BD-454CF787ADC8}" destId="{1A1285A5-BDA8-4319-9B18-A272AE807501}" srcOrd="1" destOrd="0" parTransId="{E26C83CB-467D-45AD-848C-3AFEDEE37424}" sibTransId="{A9C9E6D4-16C4-41BD-964C-0D4FE940A841}"/>
    <dgm:cxn modelId="{F33DF81B-2FA9-4014-B3DB-AE8A1187B2C9}" type="presOf" srcId="{50C9D290-0252-410F-A1BD-454CF787ADC8}" destId="{C7869398-6C49-4AB9-8205-101672020437}" srcOrd="0" destOrd="0" presId="urn:microsoft.com/office/officeart/2005/8/layout/radial3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350AADEF-B36A-43E9-9C9B-5FD46A57DDAA}" type="presOf" srcId="{FF307E38-E9EA-48C7-BB5D-7186A49E7AB2}" destId="{72EDB95F-2EA1-401F-AF4F-043134B29286}" srcOrd="0" destOrd="0" presId="urn:microsoft.com/office/officeart/2005/8/layout/radial3"/>
    <dgm:cxn modelId="{46572AC4-46BD-4A17-A129-69026AD98BFE}" type="presOf" srcId="{1A1285A5-BDA8-4319-9B18-A272AE807501}" destId="{8262EBD1-2017-484A-9727-5BB0DEA45C1E}" srcOrd="0" destOrd="0" presId="urn:microsoft.com/office/officeart/2005/8/layout/radial3"/>
    <dgm:cxn modelId="{5970E265-811F-4966-BAF8-065AC74C387A}" type="presOf" srcId="{29F58F62-2558-46D7-A230-720F7B055378}" destId="{CEE8EC5F-8DBF-44DF-8446-C990E41D50F6}" srcOrd="0" destOrd="0" presId="urn:microsoft.com/office/officeart/2005/8/layout/radial3"/>
    <dgm:cxn modelId="{B3C6C3F4-339C-44C2-B325-F6CCAE3FDDF9}" srcId="{50C9D290-0252-410F-A1BD-454CF787ADC8}" destId="{FF307E38-E9EA-48C7-BB5D-7186A49E7AB2}" srcOrd="3" destOrd="0" parTransId="{E752D029-C0D8-438D-BDDF-ADBDBB5D708A}" sibTransId="{B385C5A4-42F9-4644-9246-1AF9FC506284}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37E7AC17-C2FF-40B7-A29D-197BE80C8939}" type="presOf" srcId="{B46FB715-7AFC-451B-9469-DD324419BDC1}" destId="{DE96DFF5-015F-4F59-A3BB-E4577278E7CE}" srcOrd="0" destOrd="0" presId="urn:microsoft.com/office/officeart/2005/8/layout/radial3"/>
    <dgm:cxn modelId="{DFFBE8A0-CBF3-4163-B8BE-A3D3C9A64352}" type="presOf" srcId="{D6F84C29-B6D5-4E7D-BDD6-569F8EC9E27C}" destId="{614F53D1-4287-4607-B43A-D85A0FCF661E}" srcOrd="0" destOrd="0" presId="urn:microsoft.com/office/officeart/2005/8/layout/radial3"/>
    <dgm:cxn modelId="{4FB4442C-5614-4E26-A1E8-CBE28EF8FFBB}" srcId="{50C9D290-0252-410F-A1BD-454CF787ADC8}" destId="{D6F84C29-B6D5-4E7D-BDD6-569F8EC9E27C}" srcOrd="4" destOrd="0" parTransId="{50857628-DD61-4A89-861A-FD844547EBD0}" sibTransId="{903494E9-1B93-4790-87F7-6187FC54F61D}"/>
    <dgm:cxn modelId="{6B30FDDE-89C1-4A42-88DB-0E4BB91426C2}" srcId="{50C9D290-0252-410F-A1BD-454CF787ADC8}" destId="{E3F7EF6D-D1CE-43BF-9EED-CCEADA0930F4}" srcOrd="2" destOrd="0" parTransId="{A8EC8D59-92BD-4DB8-B755-C2D0942606BB}" sibTransId="{6DF65815-CAEA-498B-A0ED-E0A39EA33A85}"/>
    <dgm:cxn modelId="{1B83F487-009E-4022-97A4-F5F23B18BABB}" srcId="{50C9D290-0252-410F-A1BD-454CF787ADC8}" destId="{29F58F62-2558-46D7-A230-720F7B055378}" srcOrd="8" destOrd="0" parTransId="{386718D0-449E-496D-8D69-A4AC9344CE34}" sibTransId="{2E8D8F35-9B11-49D3-8837-BDCBC81252A7}"/>
    <dgm:cxn modelId="{D1D702D5-14B8-4349-B0E0-B73BF0E06742}" type="presOf" srcId="{E3F7EF6D-D1CE-43BF-9EED-CCEADA0930F4}" destId="{ADF31E19-3513-45A4-9241-2348A1B01016}" srcOrd="0" destOrd="0" presId="urn:microsoft.com/office/officeart/2005/8/layout/radial3"/>
    <dgm:cxn modelId="{59A6E890-A7FB-42E8-93C4-61AAD0EED7D5}" type="presParOf" srcId="{2D3A3C69-23CC-4073-9BB5-7173DB1B5AC6}" destId="{47F6CD61-8625-493D-AAC4-E6F2B2EEE924}" srcOrd="0" destOrd="0" presId="urn:microsoft.com/office/officeart/2005/8/layout/radial3"/>
    <dgm:cxn modelId="{065F851C-EBD4-46EB-8F6F-CFF1F44647E3}" type="presParOf" srcId="{47F6CD61-8625-493D-AAC4-E6F2B2EEE924}" destId="{C7869398-6C49-4AB9-8205-101672020437}" srcOrd="0" destOrd="0" presId="urn:microsoft.com/office/officeart/2005/8/layout/radial3"/>
    <dgm:cxn modelId="{AEC11EF5-5937-443C-B5CA-F167FF1AAF2A}" type="presParOf" srcId="{47F6CD61-8625-493D-AAC4-E6F2B2EEE924}" destId="{8EF7DFA6-5C81-4E45-BE91-EE20E9FAE56A}" srcOrd="1" destOrd="0" presId="urn:microsoft.com/office/officeart/2005/8/layout/radial3"/>
    <dgm:cxn modelId="{1C83E8B4-377A-4CAC-BF8F-A9C00647CEDC}" type="presParOf" srcId="{47F6CD61-8625-493D-AAC4-E6F2B2EEE924}" destId="{8262EBD1-2017-484A-9727-5BB0DEA45C1E}" srcOrd="2" destOrd="0" presId="urn:microsoft.com/office/officeart/2005/8/layout/radial3"/>
    <dgm:cxn modelId="{569A8DEF-C82E-4D85-9447-8B64359C41FC}" type="presParOf" srcId="{47F6CD61-8625-493D-AAC4-E6F2B2EEE924}" destId="{ADF31E19-3513-45A4-9241-2348A1B01016}" srcOrd="3" destOrd="0" presId="urn:microsoft.com/office/officeart/2005/8/layout/radial3"/>
    <dgm:cxn modelId="{5A26EB0D-689A-4AD7-B930-EBDEF5CD32D0}" type="presParOf" srcId="{47F6CD61-8625-493D-AAC4-E6F2B2EEE924}" destId="{72EDB95F-2EA1-401F-AF4F-043134B29286}" srcOrd="4" destOrd="0" presId="urn:microsoft.com/office/officeart/2005/8/layout/radial3"/>
    <dgm:cxn modelId="{DB2CD7BA-7257-491A-BF7D-4AC16A1DA48E}" type="presParOf" srcId="{47F6CD61-8625-493D-AAC4-E6F2B2EEE924}" destId="{614F53D1-4287-4607-B43A-D85A0FCF661E}" srcOrd="5" destOrd="0" presId="urn:microsoft.com/office/officeart/2005/8/layout/radial3"/>
    <dgm:cxn modelId="{84C517A5-15E6-4B59-9606-0601B5B40BFB}" type="presParOf" srcId="{47F6CD61-8625-493D-AAC4-E6F2B2EEE924}" destId="{28C80B8C-BF19-4581-9A31-F40D8D8E3B6C}" srcOrd="6" destOrd="0" presId="urn:microsoft.com/office/officeart/2005/8/layout/radial3"/>
    <dgm:cxn modelId="{B9DE57CF-EAE1-48D0-979E-A974EB3A3F68}" type="presParOf" srcId="{47F6CD61-8625-493D-AAC4-E6F2B2EEE924}" destId="{DE96DFF5-015F-4F59-A3BB-E4577278E7CE}" srcOrd="7" destOrd="0" presId="urn:microsoft.com/office/officeart/2005/8/layout/radial3"/>
    <dgm:cxn modelId="{4B50E860-CC23-4B9F-B450-4FAC3F9D7078}" type="presParOf" srcId="{47F6CD61-8625-493D-AAC4-E6F2B2EEE924}" destId="{0D2FAAFB-6C18-4DA1-95E4-D13601D68C8A}" srcOrd="8" destOrd="0" presId="urn:microsoft.com/office/officeart/2005/8/layout/radial3"/>
    <dgm:cxn modelId="{3B31E1E8-BAFF-4129-A7BB-5E58C421D549}" type="presParOf" srcId="{47F6CD61-8625-493D-AAC4-E6F2B2EEE924}" destId="{CEE8EC5F-8DBF-44DF-8446-C990E41D50F6}" srcOrd="9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2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9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800" b="0" dirty="0" err="1" smtClean="0">
              <a:latin typeface="Arial" panose="020B0604020202020204" pitchFamily="34" charset="0"/>
              <a:cs typeface="Arial" panose="020B0604020202020204" pitchFamily="34" charset="0"/>
            </a:rPr>
            <a:t>seizures</a:t>
          </a:r>
          <a:endParaRPr lang="es-ES" sz="8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800" dirty="0" smtClean="0">
              <a:latin typeface="Arial" panose="020B0604020202020204" pitchFamily="34" charset="0"/>
              <a:cs typeface="Arial" panose="020B0604020202020204" pitchFamily="34" charset="0"/>
            </a:rPr>
            <a:t>Short philtrum</a:t>
          </a:r>
          <a:endParaRPr lang="es-E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800" dirty="0" err="1" smtClean="0">
              <a:latin typeface="Arial" panose="020B0604020202020204" pitchFamily="34" charset="0"/>
              <a:cs typeface="Arial" panose="020B0604020202020204" pitchFamily="34" charset="0"/>
            </a:rPr>
            <a:t>Enlarged</a:t>
          </a:r>
          <a:r>
            <a:rPr lang="es-ES" sz="8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8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9CEF480-F38B-426E-BC84-54E4F61CC0CE}">
      <dgm:prSet phldrT="[Texto]" custT="1"/>
      <dgm:spPr/>
      <dgm:t>
        <a:bodyPr/>
        <a:lstStyle/>
        <a:p>
          <a:r>
            <a:rPr lang="es-ES" sz="800" b="0" dirty="0" smtClean="0">
              <a:latin typeface="Arial" panose="020B0604020202020204" pitchFamily="34" charset="0"/>
              <a:cs typeface="Arial" panose="020B0604020202020204" pitchFamily="34" charset="0"/>
            </a:rPr>
            <a:t>ASD</a:t>
          </a:r>
          <a:endParaRPr lang="es-ES" sz="8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1BD2AB-E820-408A-AD8F-A7936B0F510E}" type="par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1F29BDC-E76E-4482-891B-BD4E70E2E1EB}" type="sib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5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5" custRadScaleRad="88279" custRadScaleInc="7240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C5CB0D0-51D5-4107-B5AD-34AD4AEC6DB6}" type="pres">
      <dgm:prSet presAssocID="{79CEF480-F38B-426E-BC84-54E4F61CC0CE}" presName="node" presStyleLbl="vennNode1" presStyleIdx="2" presStyleCnt="5" custScaleX="111119" custRadScaleRad="89254" custRadScaleInc="3537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3" presStyleCnt="5" custScaleX="117356" custRadScaleRad="92126" custRadScaleInc="176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4" presStyleCnt="5" custRadScaleRad="93093" custRadScaleInc="8453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DE2C4248-750A-4A58-9493-B1BB87906778}" srcId="{50C9D290-0252-410F-A1BD-454CF787ADC8}" destId="{0527C542-23FD-4E97-9F9F-A34A08934BE5}" srcOrd="3" destOrd="0" parTransId="{5A7F3E19-4746-495F-AEC8-77E3AB4066C6}" sibTransId="{D0B1DDB7-ED91-4CF5-8E22-D433DAD15D99}"/>
    <dgm:cxn modelId="{81980C98-2361-4F70-A5B0-02A2A4EE36CD}" type="presOf" srcId="{50C9D290-0252-410F-A1BD-454CF787ADC8}" destId="{C7869398-6C49-4AB9-8205-101672020437}" srcOrd="0" destOrd="0" presId="urn:microsoft.com/office/officeart/2005/8/layout/radial3"/>
    <dgm:cxn modelId="{6B30FDDE-89C1-4A42-88DB-0E4BB91426C2}" srcId="{50C9D290-0252-410F-A1BD-454CF787ADC8}" destId="{E3F7EF6D-D1CE-43BF-9EED-CCEADA0930F4}" srcOrd="2" destOrd="0" parTransId="{A8EC8D59-92BD-4DB8-B755-C2D0942606BB}" sibTransId="{6DF65815-CAEA-498B-A0ED-E0A39EA33A85}"/>
    <dgm:cxn modelId="{4B07862D-74B7-4E41-A422-E215367A8D23}" type="presOf" srcId="{C72F6624-5DD3-4F43-A003-0ED4444787BB}" destId="{2D3A3C69-23CC-4073-9BB5-7173DB1B5AC6}" srcOrd="0" destOrd="0" presId="urn:microsoft.com/office/officeart/2005/8/layout/radial3"/>
    <dgm:cxn modelId="{55908716-088A-4A0D-A231-C6DDB152460E}" type="presOf" srcId="{E3F7EF6D-D1CE-43BF-9EED-CCEADA0930F4}" destId="{ADF31E19-3513-45A4-9241-2348A1B01016}" srcOrd="0" destOrd="0" presId="urn:microsoft.com/office/officeart/2005/8/layout/radial3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20F89C61-EB6E-4B67-9AA2-CC3151FA4A3A}" type="presOf" srcId="{A90C8DF0-9A4B-41D3-A6EB-D9A783D586B9}" destId="{8EF7DFA6-5C81-4E45-BE91-EE20E9FAE56A}" srcOrd="0" destOrd="0" presId="urn:microsoft.com/office/officeart/2005/8/layout/radial3"/>
    <dgm:cxn modelId="{ACCAB7D1-D875-44C1-9EFE-8DB691F3D5AB}" type="presOf" srcId="{79CEF480-F38B-426E-BC84-54E4F61CC0CE}" destId="{7C5CB0D0-51D5-4107-B5AD-34AD4AEC6DB6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BD98A985-9329-4E9B-A84D-BAD364387D02}" type="presOf" srcId="{0527C542-23FD-4E97-9F9F-A34A08934BE5}" destId="{0D2FAAFB-6C18-4DA1-95E4-D13601D68C8A}" srcOrd="0" destOrd="0" presId="urn:microsoft.com/office/officeart/2005/8/layout/radial3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12CED13A-C97B-4EB0-853F-D7CAEC239050}" srcId="{50C9D290-0252-410F-A1BD-454CF787ADC8}" destId="{79CEF480-F38B-426E-BC84-54E4F61CC0CE}" srcOrd="1" destOrd="0" parTransId="{8D1BD2AB-E820-408A-AD8F-A7936B0F510E}" sibTransId="{01F29BDC-E76E-4482-891B-BD4E70E2E1EB}"/>
    <dgm:cxn modelId="{5F527320-9285-4AEB-8CC1-E51516779690}" type="presParOf" srcId="{2D3A3C69-23CC-4073-9BB5-7173DB1B5AC6}" destId="{47F6CD61-8625-493D-AAC4-E6F2B2EEE924}" srcOrd="0" destOrd="0" presId="urn:microsoft.com/office/officeart/2005/8/layout/radial3"/>
    <dgm:cxn modelId="{1BACE134-D371-4B21-960B-5121DD64AB72}" type="presParOf" srcId="{47F6CD61-8625-493D-AAC4-E6F2B2EEE924}" destId="{C7869398-6C49-4AB9-8205-101672020437}" srcOrd="0" destOrd="0" presId="urn:microsoft.com/office/officeart/2005/8/layout/radial3"/>
    <dgm:cxn modelId="{5E6903F1-8EA2-418E-A465-541C3E671B05}" type="presParOf" srcId="{47F6CD61-8625-493D-AAC4-E6F2B2EEE924}" destId="{8EF7DFA6-5C81-4E45-BE91-EE20E9FAE56A}" srcOrd="1" destOrd="0" presId="urn:microsoft.com/office/officeart/2005/8/layout/radial3"/>
    <dgm:cxn modelId="{EBA132A3-3A9A-4453-B012-C48E4C9D34B7}" type="presParOf" srcId="{47F6CD61-8625-493D-AAC4-E6F2B2EEE924}" destId="{7C5CB0D0-51D5-4107-B5AD-34AD4AEC6DB6}" srcOrd="2" destOrd="0" presId="urn:microsoft.com/office/officeart/2005/8/layout/radial3"/>
    <dgm:cxn modelId="{15033630-CFB7-4D4A-8E4C-BC557D825F4B}" type="presParOf" srcId="{47F6CD61-8625-493D-AAC4-E6F2B2EEE924}" destId="{ADF31E19-3513-45A4-9241-2348A1B01016}" srcOrd="3" destOrd="0" presId="urn:microsoft.com/office/officeart/2005/8/layout/radial3"/>
    <dgm:cxn modelId="{ACDA32C5-3651-41F2-8418-A0645355950D}" type="presParOf" srcId="{47F6CD61-8625-493D-AAC4-E6F2B2EEE924}" destId="{0D2FAAFB-6C18-4DA1-95E4-D13601D68C8A}" srcOrd="4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31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m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 (-)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1285A5-BDA8-4319-9B18-A272AE807501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to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walk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C83CB-467D-45AD-848C-3AFEDEE37424}" type="par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C9E6D4-16C4-41BD-964C-0D4FE940A841}" type="sibTrans" cxnId="{B6750CD8-014E-443D-92FE-E3E23E4B21BA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Normal EEG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Can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read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/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write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527C542-23FD-4E97-9F9F-A34A08934BE5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Use </a:t>
          </a:r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 (-)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F3E19-4746-495F-AEC8-77E3AB4066C6}" type="par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0B1DDB7-ED91-4CF5-8E22-D433DAD15D99}" type="sibTrans" cxnId="{DE2C4248-750A-4A58-9493-B1BB87906778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/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/>
        </a:p>
      </dgm:t>
    </dgm:pt>
    <dgm:pt modelId="{B95FA7B1-EF41-4BFA-8A64-78B1F67CE764}">
      <dgm:prSet phldrT="[Texto]" custT="1"/>
      <dgm:spPr/>
      <dgm:t>
        <a:bodyPr/>
        <a:lstStyle/>
        <a:p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To </a:t>
          </a:r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have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additional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duplication</a:t>
          </a:r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671F80-DAE6-4356-9BC2-82FFDD6110BB}" type="parTrans" cxnId="{628FE9C9-4C25-423D-A4F2-167CDCE8866D}">
      <dgm:prSet/>
      <dgm:spPr/>
      <dgm:t>
        <a:bodyPr/>
        <a:lstStyle/>
        <a:p>
          <a:endParaRPr lang="es-ES"/>
        </a:p>
      </dgm:t>
    </dgm:pt>
    <dgm:pt modelId="{AF5E4223-4019-4BB5-991B-A81A92CFDDC7}" type="sibTrans" cxnId="{628FE9C9-4C25-423D-A4F2-167CDCE8866D}">
      <dgm:prSet/>
      <dgm:spPr/>
      <dgm:t>
        <a:bodyPr/>
        <a:lstStyle/>
        <a:p>
          <a:endParaRPr lang="es-ES"/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7" custLinFactNeighborX="-2214" custLinFactNeighborY="784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7" custScaleX="139601" custRadScaleRad="93899" custRadScaleInc="-16963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B3CAD86-439D-450E-8B31-7A2D97EFB1C6}" type="pres">
      <dgm:prSet presAssocID="{B95FA7B1-EF41-4BFA-8A64-78B1F67CE764}" presName="node" presStyleLbl="vennNode1" presStyleIdx="2" presStyleCnt="7" custScaleX="178520" custRadScaleRad="97765" custRadScaleInc="-9209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8262EBD1-2017-484A-9727-5BB0DEA45C1E}" type="pres">
      <dgm:prSet presAssocID="{1A1285A5-BDA8-4319-9B18-A272AE807501}" presName="node" presStyleLbl="vennNode1" presStyleIdx="3" presStyleCnt="7" custScaleX="117356" custRadScaleRad="87455" custRadScaleInc="-102584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4" presStyleCnt="7" custScaleX="145480" custRadScaleRad="91254" custRadScaleInc="209367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5" presStyleCnt="7" custScaleX="141903" custRadScaleRad="88685" custRadScaleInc="-217764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0D2FAAFB-6C18-4DA1-95E4-D13601D68C8A}" type="pres">
      <dgm:prSet presAssocID="{0527C542-23FD-4E97-9F9F-A34A08934BE5}" presName="node" presStyleLbl="vennNode1" presStyleIdx="6" presStyleCnt="7" custScaleX="144379" custRadScaleRad="83096" custRadScaleInc="-222734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815A011F-C9EC-4C7A-A7EE-1118AF8083AE}" type="presOf" srcId="{C72F6624-5DD3-4F43-A003-0ED4444787BB}" destId="{2D3A3C69-23CC-4073-9BB5-7173DB1B5AC6}" srcOrd="0" destOrd="0" presId="urn:microsoft.com/office/officeart/2005/8/layout/radial3"/>
    <dgm:cxn modelId="{F535BB1F-ED15-4F51-8986-209FD2C5144D}" type="presOf" srcId="{0527C542-23FD-4E97-9F9F-A34A08934BE5}" destId="{0D2FAAFB-6C18-4DA1-95E4-D13601D68C8A}" srcOrd="0" destOrd="0" presId="urn:microsoft.com/office/officeart/2005/8/layout/radial3"/>
    <dgm:cxn modelId="{DE2C4248-750A-4A58-9493-B1BB87906778}" srcId="{50C9D290-0252-410F-A1BD-454CF787ADC8}" destId="{0527C542-23FD-4E97-9F9F-A34A08934BE5}" srcOrd="5" destOrd="0" parTransId="{5A7F3E19-4746-495F-AEC8-77E3AB4066C6}" sibTransId="{D0B1DDB7-ED91-4CF5-8E22-D433DAD15D99}"/>
    <dgm:cxn modelId="{15913AC3-59AB-4A4D-A953-B559B444C8D1}" type="presOf" srcId="{A90C8DF0-9A4B-41D3-A6EB-D9A783D586B9}" destId="{8EF7DFA6-5C81-4E45-BE91-EE20E9FAE56A}" srcOrd="0" destOrd="0" presId="urn:microsoft.com/office/officeart/2005/8/layout/radial3"/>
    <dgm:cxn modelId="{D4BAE58B-A45C-4FC9-84DF-BA7CC4D24D36}" type="presOf" srcId="{D6F84C29-B6D5-4E7D-BDD6-569F8EC9E27C}" destId="{614F53D1-4287-4607-B43A-D85A0FCF661E}" srcOrd="0" destOrd="0" presId="urn:microsoft.com/office/officeart/2005/8/layout/radial3"/>
    <dgm:cxn modelId="{7C52A876-6248-4650-90E3-D50FC1908B5B}" srcId="{50C9D290-0252-410F-A1BD-454CF787ADC8}" destId="{B46FB715-7AFC-451B-9469-DD324419BDC1}" srcOrd="4" destOrd="0" parTransId="{E0CE2B5E-4E85-46A0-8B69-7163AB1BDCA6}" sibTransId="{BC5E5B88-F594-4024-99F1-EA04404C6DF2}"/>
    <dgm:cxn modelId="{B6750CD8-014E-443D-92FE-E3E23E4B21BA}" srcId="{50C9D290-0252-410F-A1BD-454CF787ADC8}" destId="{1A1285A5-BDA8-4319-9B18-A272AE807501}" srcOrd="2" destOrd="0" parTransId="{E26C83CB-467D-45AD-848C-3AFEDEE37424}" sibTransId="{A9C9E6D4-16C4-41BD-964C-0D4FE940A841}"/>
    <dgm:cxn modelId="{A411E98F-F1EC-4883-A918-5253D9476B17}" type="presOf" srcId="{B46FB715-7AFC-451B-9469-DD324419BDC1}" destId="{DE96DFF5-015F-4F59-A3BB-E4577278E7CE}" srcOrd="0" destOrd="0" presId="urn:microsoft.com/office/officeart/2005/8/layout/radial3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A2164554-8482-4BCD-AA2A-739AA8B9FABB}" type="presOf" srcId="{1A1285A5-BDA8-4319-9B18-A272AE807501}" destId="{8262EBD1-2017-484A-9727-5BB0DEA45C1E}" srcOrd="0" destOrd="0" presId="urn:microsoft.com/office/officeart/2005/8/layout/radial3"/>
    <dgm:cxn modelId="{84D3F90B-CD34-4D39-92E7-20F65772FC20}" type="presOf" srcId="{B95FA7B1-EF41-4BFA-8A64-78B1F67CE764}" destId="{AB3CAD86-439D-450E-8B31-7A2D97EFB1C6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BCC4A70D-B207-465A-A80A-FE7A785F1813}" type="presOf" srcId="{50C9D290-0252-410F-A1BD-454CF787ADC8}" destId="{C7869398-6C49-4AB9-8205-101672020437}" srcOrd="0" destOrd="0" presId="urn:microsoft.com/office/officeart/2005/8/layout/radial3"/>
    <dgm:cxn modelId="{4FB4442C-5614-4E26-A1E8-CBE28EF8FFBB}" srcId="{50C9D290-0252-410F-A1BD-454CF787ADC8}" destId="{D6F84C29-B6D5-4E7D-BDD6-569F8EC9E27C}" srcOrd="3" destOrd="0" parTransId="{50857628-DD61-4A89-861A-FD844547EBD0}" sibTransId="{903494E9-1B93-4790-87F7-6187FC54F61D}"/>
    <dgm:cxn modelId="{628FE9C9-4C25-423D-A4F2-167CDCE8866D}" srcId="{50C9D290-0252-410F-A1BD-454CF787ADC8}" destId="{B95FA7B1-EF41-4BFA-8A64-78B1F67CE764}" srcOrd="1" destOrd="0" parTransId="{3C671F80-DAE6-4356-9BC2-82FFDD6110BB}" sibTransId="{AF5E4223-4019-4BB5-991B-A81A92CFDDC7}"/>
    <dgm:cxn modelId="{5A42777F-0F34-448B-B91E-4457A250C50E}" type="presParOf" srcId="{2D3A3C69-23CC-4073-9BB5-7173DB1B5AC6}" destId="{47F6CD61-8625-493D-AAC4-E6F2B2EEE924}" srcOrd="0" destOrd="0" presId="urn:microsoft.com/office/officeart/2005/8/layout/radial3"/>
    <dgm:cxn modelId="{A84C1B86-4DE9-47B3-821A-B2BF6C38ECBC}" type="presParOf" srcId="{47F6CD61-8625-493D-AAC4-E6F2B2EEE924}" destId="{C7869398-6C49-4AB9-8205-101672020437}" srcOrd="0" destOrd="0" presId="urn:microsoft.com/office/officeart/2005/8/layout/radial3"/>
    <dgm:cxn modelId="{8C0A6ACB-6511-49E8-B362-5095F878160F}" type="presParOf" srcId="{47F6CD61-8625-493D-AAC4-E6F2B2EEE924}" destId="{8EF7DFA6-5C81-4E45-BE91-EE20E9FAE56A}" srcOrd="1" destOrd="0" presId="urn:microsoft.com/office/officeart/2005/8/layout/radial3"/>
    <dgm:cxn modelId="{D5F1C592-BDD4-44E3-A14F-01C3565B24BC}" type="presParOf" srcId="{47F6CD61-8625-493D-AAC4-E6F2B2EEE924}" destId="{AB3CAD86-439D-450E-8B31-7A2D97EFB1C6}" srcOrd="2" destOrd="0" presId="urn:microsoft.com/office/officeart/2005/8/layout/radial3"/>
    <dgm:cxn modelId="{5671131D-DBB4-4017-BB26-F2C27DCE04FC}" type="presParOf" srcId="{47F6CD61-8625-493D-AAC4-E6F2B2EEE924}" destId="{8262EBD1-2017-484A-9727-5BB0DEA45C1E}" srcOrd="3" destOrd="0" presId="urn:microsoft.com/office/officeart/2005/8/layout/radial3"/>
    <dgm:cxn modelId="{4C52ACA7-A0E9-4DEE-9868-354B2C1FDF03}" type="presParOf" srcId="{47F6CD61-8625-493D-AAC4-E6F2B2EEE924}" destId="{614F53D1-4287-4607-B43A-D85A0FCF661E}" srcOrd="4" destOrd="0" presId="urn:microsoft.com/office/officeart/2005/8/layout/radial3"/>
    <dgm:cxn modelId="{31C1882D-A22E-4CE4-AFAE-F661AD30533A}" type="presParOf" srcId="{47F6CD61-8625-493D-AAC4-E6F2B2EEE924}" destId="{DE96DFF5-015F-4F59-A3BB-E4577278E7CE}" srcOrd="5" destOrd="0" presId="urn:microsoft.com/office/officeart/2005/8/layout/radial3"/>
    <dgm:cxn modelId="{232ABC95-FAA6-4D2D-86C5-145BA0B81018}" type="presParOf" srcId="{47F6CD61-8625-493D-AAC4-E6F2B2EEE924}" destId="{0D2FAAFB-6C18-4DA1-95E4-D13601D68C8A}" srcOrd="6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36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D6F84C29-B6D5-4E7D-BDD6-569F8EC9E27C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857628-DD61-4A89-861A-FD844547EBD0}" type="par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03494E9-1B93-4790-87F7-6187FC54F61D}" type="sibTrans" cxnId="{4FB4442C-5614-4E26-A1E8-CBE28EF8FFB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46FB715-7AFC-451B-9469-DD324419BDC1}">
      <dgm:prSet phldrT="[Texto]" custT="1"/>
      <dgm:spPr/>
      <dgm:t>
        <a:bodyPr/>
        <a:lstStyle/>
        <a:p>
          <a:r>
            <a:rPr lang="es-ES" sz="7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CE2B5E-4E85-46A0-8B69-7163AB1BDCA6}" type="par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C5E5B88-F594-4024-99F1-EA04404C6DF2}" type="sibTrans" cxnId="{7C52A876-6248-4650-90E3-D50FC1908B5B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/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5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3" custLinFactNeighborX="140" custLinFactNeighborY="-2341"/>
      <dgm:spPr/>
      <dgm:t>
        <a:bodyPr/>
        <a:lstStyle/>
        <a:p>
          <a:endParaRPr lang="es-ES"/>
        </a:p>
      </dgm:t>
    </dgm:pt>
    <dgm:pt modelId="{614F53D1-4287-4607-B43A-D85A0FCF661E}" type="pres">
      <dgm:prSet presAssocID="{D6F84C29-B6D5-4E7D-BDD6-569F8EC9E27C}" presName="node" presStyleLbl="vennNode1" presStyleIdx="1" presStyleCnt="3" custScaleX="229696" custRadScaleRad="103407" custRadScaleInc="-6429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DE96DFF5-015F-4F59-A3BB-E4577278E7CE}" type="pres">
      <dgm:prSet presAssocID="{B46FB715-7AFC-451B-9469-DD324419BDC1}" presName="node" presStyleLbl="vennNode1" presStyleIdx="2" presStyleCnt="3" custScaleX="168753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7C52A876-6248-4650-90E3-D50FC1908B5B}" srcId="{50C9D290-0252-410F-A1BD-454CF787ADC8}" destId="{B46FB715-7AFC-451B-9469-DD324419BDC1}" srcOrd="1" destOrd="0" parTransId="{E0CE2B5E-4E85-46A0-8B69-7163AB1BDCA6}" sibTransId="{BC5E5B88-F594-4024-99F1-EA04404C6DF2}"/>
    <dgm:cxn modelId="{AAD5047A-B6EC-408B-B78F-86639306F910}" type="presOf" srcId="{50C9D290-0252-410F-A1BD-454CF787ADC8}" destId="{C7869398-6C49-4AB9-8205-101672020437}" srcOrd="0" destOrd="0" presId="urn:microsoft.com/office/officeart/2005/8/layout/radial3"/>
    <dgm:cxn modelId="{4FB4442C-5614-4E26-A1E8-CBE28EF8FFBB}" srcId="{50C9D290-0252-410F-A1BD-454CF787ADC8}" destId="{D6F84C29-B6D5-4E7D-BDD6-569F8EC9E27C}" srcOrd="0" destOrd="0" parTransId="{50857628-DD61-4A89-861A-FD844547EBD0}" sibTransId="{903494E9-1B93-4790-87F7-6187FC54F61D}"/>
    <dgm:cxn modelId="{B49C32F8-9134-4E43-8C3E-610BB4CD82E7}" type="presOf" srcId="{C72F6624-5DD3-4F43-A003-0ED4444787BB}" destId="{2D3A3C69-23CC-4073-9BB5-7173DB1B5AC6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D03F985C-E072-4781-9B26-47E8AF81DFDE}" type="presOf" srcId="{B46FB715-7AFC-451B-9469-DD324419BDC1}" destId="{DE96DFF5-015F-4F59-A3BB-E4577278E7CE}" srcOrd="0" destOrd="0" presId="urn:microsoft.com/office/officeart/2005/8/layout/radial3"/>
    <dgm:cxn modelId="{4F6FC95E-AE6B-458C-9FA7-986FA76A9FAC}" type="presOf" srcId="{D6F84C29-B6D5-4E7D-BDD6-569F8EC9E27C}" destId="{614F53D1-4287-4607-B43A-D85A0FCF661E}" srcOrd="0" destOrd="0" presId="urn:microsoft.com/office/officeart/2005/8/layout/radial3"/>
    <dgm:cxn modelId="{5B13E28D-94D9-45E4-BCF9-B21484D0997E}" type="presParOf" srcId="{2D3A3C69-23CC-4073-9BB5-7173DB1B5AC6}" destId="{47F6CD61-8625-493D-AAC4-E6F2B2EEE924}" srcOrd="0" destOrd="0" presId="urn:microsoft.com/office/officeart/2005/8/layout/radial3"/>
    <dgm:cxn modelId="{6617FBD2-7D10-43E5-8AA5-42E099048A3E}" type="presParOf" srcId="{47F6CD61-8625-493D-AAC4-E6F2B2EEE924}" destId="{C7869398-6C49-4AB9-8205-101672020437}" srcOrd="0" destOrd="0" presId="urn:microsoft.com/office/officeart/2005/8/layout/radial3"/>
    <dgm:cxn modelId="{3FC2552E-BF6D-4D07-845B-0329D8C11A71}" type="presParOf" srcId="{47F6CD61-8625-493D-AAC4-E6F2B2EEE924}" destId="{614F53D1-4287-4607-B43A-D85A0FCF661E}" srcOrd="1" destOrd="0" presId="urn:microsoft.com/office/officeart/2005/8/layout/radial3"/>
    <dgm:cxn modelId="{817045C5-48B4-490A-91A1-9B42D1C7C191}" type="presParOf" srcId="{47F6CD61-8625-493D-AAC4-E6F2B2EEE924}" destId="{DE96DFF5-015F-4F59-A3BB-E4577278E7CE}" srcOrd="2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41" minVer="http://schemas.openxmlformats.org/drawingml/2006/diagram"/>
    </a:ext>
  </dgm:extLst>
</dgm:dataModel>
</file>

<file path=ppt/diagrams/data9.xml><?xml version="1.0" encoding="utf-8"?>
<dgm:dataModel xmlns:dgm="http://schemas.openxmlformats.org/drawingml/2006/diagram" xmlns:a="http://schemas.openxmlformats.org/drawingml/2006/main">
  <dgm:ptLst>
    <dgm:pt modelId="{C72F6624-5DD3-4F43-A003-0ED4444787BB}" type="doc">
      <dgm:prSet loTypeId="urn:microsoft.com/office/officeart/2005/8/layout/radial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s-ES"/>
        </a:p>
      </dgm:t>
    </dgm:pt>
    <dgm:pt modelId="{50C9D290-0252-410F-A1BD-454CF787ADC8}">
      <dgm:prSet phldrT="[Texto]" custT="1"/>
      <dgm:spPr/>
      <dgm:t>
        <a:bodyPr/>
        <a:lstStyle/>
        <a:p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7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84C90F-6255-4AB8-816F-E705986A926A}" type="par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1601AA-6AB8-4CF7-BD4C-9793DB642103}" type="sibTrans" cxnId="{152970FD-6B20-424A-A834-9B1C3CB93D57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0C8DF0-9A4B-41D3-A6EB-D9A783D586B9}">
      <dgm:prSet phldrT="[Texto]" custT="1"/>
      <dgm:spPr/>
      <dgm:t>
        <a:bodyPr/>
        <a:lstStyle/>
        <a:p>
          <a:r>
            <a:rPr lang="es-ES" sz="700" b="0" dirty="0" smtClean="0">
              <a:latin typeface="Arial" panose="020B0604020202020204" pitchFamily="34" charset="0"/>
              <a:cs typeface="Arial" panose="020B0604020202020204" pitchFamily="34" charset="0"/>
            </a:rPr>
            <a:t>ASD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DEAD0C0-B4FD-465F-91A9-5C9D23071396}" type="par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5EBC2-8A87-4646-8AE3-392474528E69}" type="sibTrans" cxnId="{AA2F43DD-04F4-459D-9BF8-69FFB7C84F55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1FF325-DCF9-43E8-8EA5-1A4F9ED7A688}">
      <dgm:prSet phldrT="[Texto]" custRadScaleRad="103067" custRadScaleInc="216984"/>
      <dgm:spPr/>
      <dgm:t>
        <a:bodyPr/>
        <a:lstStyle/>
        <a:p>
          <a:endParaRPr lang="es-ES"/>
        </a:p>
      </dgm:t>
    </dgm:pt>
    <dgm:pt modelId="{69ED066A-E99A-49F2-ACF3-7670805B99A4}" type="par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EF42D66-65B8-4D1F-9F4B-0AA85AA43C9B}" type="sibTrans" cxnId="{33166F10-9362-49D1-8F90-59F3892E5D4F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3F7EF6D-D1CE-43BF-9EED-CCEADA0930F4}">
      <dgm:prSet phldrT="[Texto]" custT="1"/>
      <dgm:spPr/>
      <dgm:t>
        <a:bodyPr/>
        <a:lstStyle/>
        <a:p>
          <a:r>
            <a:rPr lang="es-ES" sz="700" dirty="0" smtClean="0">
              <a:latin typeface="Arial" panose="020B0604020202020204" pitchFamily="34" charset="0"/>
              <a:cs typeface="Arial" panose="020B0604020202020204" pitchFamily="34" charset="0"/>
            </a:rPr>
            <a:t>Short philtrum</a:t>
          </a:r>
          <a:endParaRPr lang="es-ES" sz="7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8EC8D59-92BD-4DB8-B755-C2D0942606BB}" type="par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DF65815-CAEA-498B-A0ED-E0A39EA33A85}" type="sibTrans" cxnId="{6B30FDDE-89C1-4A42-88DB-0E4BB91426C2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9CEF480-F38B-426E-BC84-54E4F61CC0CE}">
      <dgm:prSet phldrT="[Texto]" custT="1"/>
      <dgm:spPr/>
      <dgm:t>
        <a:bodyPr/>
        <a:lstStyle/>
        <a:p>
          <a:r>
            <a:rPr lang="es-ES" sz="700" b="0" dirty="0" err="1" smtClean="0">
              <a:latin typeface="Arial" panose="020B0604020202020204" pitchFamily="34" charset="0"/>
              <a:cs typeface="Arial" panose="020B0604020202020204" pitchFamily="34" charset="0"/>
            </a:rPr>
            <a:t>seizures</a:t>
          </a:r>
          <a:endParaRPr lang="es-ES" sz="700" b="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1BD2AB-E820-408A-AD8F-A7936B0F510E}" type="par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1F29BDC-E76E-4482-891B-BD4E70E2E1EB}" type="sibTrans" cxnId="{12CED13A-C97B-4EB0-853F-D7CAEC239050}">
      <dgm:prSet/>
      <dgm:spPr/>
      <dgm:t>
        <a:bodyPr/>
        <a:lstStyle/>
        <a:p>
          <a:endParaRPr lang="es-E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D3A3C69-23CC-4073-9BB5-7173DB1B5AC6}" type="pres">
      <dgm:prSet presAssocID="{C72F6624-5DD3-4F43-A003-0ED4444787BB}" presName="composite" presStyleCnt="0">
        <dgm:presLayoutVars>
          <dgm:chMax val="1"/>
          <dgm:dir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47F6CD61-8625-493D-AAC4-E6F2B2EEE924}" type="pres">
      <dgm:prSet presAssocID="{C72F6624-5DD3-4F43-A003-0ED4444787BB}" presName="radial" presStyleCnt="0">
        <dgm:presLayoutVars>
          <dgm:animLvl val="ctr"/>
        </dgm:presLayoutVars>
      </dgm:prSet>
      <dgm:spPr/>
    </dgm:pt>
    <dgm:pt modelId="{C7869398-6C49-4AB9-8205-101672020437}" type="pres">
      <dgm:prSet presAssocID="{50C9D290-0252-410F-A1BD-454CF787ADC8}" presName="centerShape" presStyleLbl="vennNode1" presStyleIdx="0" presStyleCnt="4" custLinFactNeighborX="-3417" custLinFactNeighborY="-6785"/>
      <dgm:spPr/>
      <dgm:t>
        <a:bodyPr/>
        <a:lstStyle/>
        <a:p>
          <a:endParaRPr lang="es-ES"/>
        </a:p>
      </dgm:t>
    </dgm:pt>
    <dgm:pt modelId="{8EF7DFA6-5C81-4E45-BE91-EE20E9FAE56A}" type="pres">
      <dgm:prSet presAssocID="{A90C8DF0-9A4B-41D3-A6EB-D9A783D586B9}" presName="node" presStyleLbl="vennNode1" presStyleIdx="1" presStyleCnt="4" custRadScaleRad="92246" custRadScaleInc="59662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C5CB0D0-51D5-4107-B5AD-34AD4AEC6DB6}" type="pres">
      <dgm:prSet presAssocID="{79CEF480-F38B-426E-BC84-54E4F61CC0CE}" presName="node" presStyleLbl="vennNode1" presStyleIdx="2" presStyleCnt="4" custScaleX="111119" custRadScaleRad="89254" custRadScaleInc="35370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ADF31E19-3513-45A4-9241-2348A1B01016}" type="pres">
      <dgm:prSet presAssocID="{E3F7EF6D-D1CE-43BF-9EED-CCEADA0930F4}" presName="node" presStyleLbl="vennNode1" presStyleIdx="3" presStyleCnt="4" custScaleX="117356" custRadScaleRad="92126" custRadScaleInc="1761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6B30FDDE-89C1-4A42-88DB-0E4BB91426C2}" srcId="{50C9D290-0252-410F-A1BD-454CF787ADC8}" destId="{E3F7EF6D-D1CE-43BF-9EED-CCEADA0930F4}" srcOrd="2" destOrd="0" parTransId="{A8EC8D59-92BD-4DB8-B755-C2D0942606BB}" sibTransId="{6DF65815-CAEA-498B-A0ED-E0A39EA33A85}"/>
    <dgm:cxn modelId="{152970FD-6B20-424A-A834-9B1C3CB93D57}" srcId="{C72F6624-5DD3-4F43-A003-0ED4444787BB}" destId="{50C9D290-0252-410F-A1BD-454CF787ADC8}" srcOrd="0" destOrd="0" parTransId="{C284C90F-6255-4AB8-816F-E705986A926A}" sibTransId="{571601AA-6AB8-4CF7-BD4C-9793DB642103}"/>
    <dgm:cxn modelId="{C63A0929-C21C-4CC9-B504-8F387D7C1B74}" type="presOf" srcId="{E3F7EF6D-D1CE-43BF-9EED-CCEADA0930F4}" destId="{ADF31E19-3513-45A4-9241-2348A1B01016}" srcOrd="0" destOrd="0" presId="urn:microsoft.com/office/officeart/2005/8/layout/radial3"/>
    <dgm:cxn modelId="{33166F10-9362-49D1-8F90-59F3892E5D4F}" srcId="{C72F6624-5DD3-4F43-A003-0ED4444787BB}" destId="{9A1FF325-DCF9-43E8-8EA5-1A4F9ED7A688}" srcOrd="1" destOrd="0" parTransId="{69ED066A-E99A-49F2-ACF3-7670805B99A4}" sibTransId="{FEF42D66-65B8-4D1F-9F4B-0AA85AA43C9B}"/>
    <dgm:cxn modelId="{16C739C2-D12E-40CD-8C66-B1EEBE902460}" type="presOf" srcId="{79CEF480-F38B-426E-BC84-54E4F61CC0CE}" destId="{7C5CB0D0-51D5-4107-B5AD-34AD4AEC6DB6}" srcOrd="0" destOrd="0" presId="urn:microsoft.com/office/officeart/2005/8/layout/radial3"/>
    <dgm:cxn modelId="{080EC34E-E20F-4013-94A4-4B24E34C461C}" type="presOf" srcId="{A90C8DF0-9A4B-41D3-A6EB-D9A783D586B9}" destId="{8EF7DFA6-5C81-4E45-BE91-EE20E9FAE56A}" srcOrd="0" destOrd="0" presId="urn:microsoft.com/office/officeart/2005/8/layout/radial3"/>
    <dgm:cxn modelId="{F2CA45A1-1C4B-4656-9ECE-41B366A5F944}" type="presOf" srcId="{50C9D290-0252-410F-A1BD-454CF787ADC8}" destId="{C7869398-6C49-4AB9-8205-101672020437}" srcOrd="0" destOrd="0" presId="urn:microsoft.com/office/officeart/2005/8/layout/radial3"/>
    <dgm:cxn modelId="{9E1FFDC1-D611-41B9-81AC-D475DFA1CC48}" type="presOf" srcId="{C72F6624-5DD3-4F43-A003-0ED4444787BB}" destId="{2D3A3C69-23CC-4073-9BB5-7173DB1B5AC6}" srcOrd="0" destOrd="0" presId="urn:microsoft.com/office/officeart/2005/8/layout/radial3"/>
    <dgm:cxn modelId="{AA2F43DD-04F4-459D-9BF8-69FFB7C84F55}" srcId="{50C9D290-0252-410F-A1BD-454CF787ADC8}" destId="{A90C8DF0-9A4B-41D3-A6EB-D9A783D586B9}" srcOrd="0" destOrd="0" parTransId="{ADEAD0C0-B4FD-465F-91A9-5C9D23071396}" sibTransId="{8AC5EBC2-8A87-4646-8AE3-392474528E69}"/>
    <dgm:cxn modelId="{12CED13A-C97B-4EB0-853F-D7CAEC239050}" srcId="{50C9D290-0252-410F-A1BD-454CF787ADC8}" destId="{79CEF480-F38B-426E-BC84-54E4F61CC0CE}" srcOrd="1" destOrd="0" parTransId="{8D1BD2AB-E820-408A-AD8F-A7936B0F510E}" sibTransId="{01F29BDC-E76E-4482-891B-BD4E70E2E1EB}"/>
    <dgm:cxn modelId="{41405C47-C8A8-4753-836E-533B815A7242}" type="presParOf" srcId="{2D3A3C69-23CC-4073-9BB5-7173DB1B5AC6}" destId="{47F6CD61-8625-493D-AAC4-E6F2B2EEE924}" srcOrd="0" destOrd="0" presId="urn:microsoft.com/office/officeart/2005/8/layout/radial3"/>
    <dgm:cxn modelId="{857EA328-5F7F-457A-A56D-DD50DAC99154}" type="presParOf" srcId="{47F6CD61-8625-493D-AAC4-E6F2B2EEE924}" destId="{C7869398-6C49-4AB9-8205-101672020437}" srcOrd="0" destOrd="0" presId="urn:microsoft.com/office/officeart/2005/8/layout/radial3"/>
    <dgm:cxn modelId="{81248A8B-5EBC-41EF-BA0A-705051BFF335}" type="presParOf" srcId="{47F6CD61-8625-493D-AAC4-E6F2B2EEE924}" destId="{8EF7DFA6-5C81-4E45-BE91-EE20E9FAE56A}" srcOrd="1" destOrd="0" presId="urn:microsoft.com/office/officeart/2005/8/layout/radial3"/>
    <dgm:cxn modelId="{533F22F9-37C0-4BA7-9166-B2F8D6A882E3}" type="presParOf" srcId="{47F6CD61-8625-493D-AAC4-E6F2B2EEE924}" destId="{7C5CB0D0-51D5-4107-B5AD-34AD4AEC6DB6}" srcOrd="2" destOrd="0" presId="urn:microsoft.com/office/officeart/2005/8/layout/radial3"/>
    <dgm:cxn modelId="{30063E01-7BA8-46EB-8CEB-A85B5F793542}" type="presParOf" srcId="{47F6CD61-8625-493D-AAC4-E6F2B2EEE924}" destId="{ADF31E19-3513-45A4-9241-2348A1B01016}" srcOrd="3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4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274941" y="464719"/>
          <a:ext cx="1129003" cy="1129003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40280" y="630058"/>
        <a:ext cx="798325" cy="798325"/>
      </dsp:txXfrm>
    </dsp:sp>
    <dsp:sp modelId="{8EF7DFA6-5C81-4E45-BE91-EE20E9FAE56A}">
      <dsp:nvSpPr>
        <dsp:cNvPr id="0" name=""/>
        <dsp:cNvSpPr/>
      </dsp:nvSpPr>
      <dsp:spPr>
        <a:xfrm>
          <a:off x="771925" y="512382"/>
          <a:ext cx="788049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87332" y="595051"/>
        <a:ext cx="557235" cy="399163"/>
      </dsp:txXfrm>
    </dsp:sp>
    <dsp:sp modelId="{9770CDF7-8417-4BBA-9FBC-F8390177E143}">
      <dsp:nvSpPr>
        <dsp:cNvPr id="0" name=""/>
        <dsp:cNvSpPr/>
      </dsp:nvSpPr>
      <dsp:spPr>
        <a:xfrm>
          <a:off x="1022519" y="118022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6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6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105188" y="200691"/>
        <a:ext cx="399163" cy="399163"/>
      </dsp:txXfrm>
    </dsp:sp>
    <dsp:sp modelId="{8262EBD1-2017-484A-9727-5BB0DEA45C1E}">
      <dsp:nvSpPr>
        <dsp:cNvPr id="0" name=""/>
        <dsp:cNvSpPr/>
      </dsp:nvSpPr>
      <dsp:spPr>
        <a:xfrm>
          <a:off x="1424965" y="0"/>
          <a:ext cx="755986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/>
            <a:t>Downturned</a:t>
          </a:r>
          <a:r>
            <a:rPr lang="es-ES" sz="700" kern="1200" dirty="0" smtClean="0"/>
            <a:t> </a:t>
          </a:r>
          <a:r>
            <a:rPr lang="es-ES" sz="700" kern="1200" dirty="0" err="1" smtClean="0"/>
            <a:t>corners</a:t>
          </a:r>
          <a:r>
            <a:rPr lang="es-ES" sz="700" kern="1200" dirty="0" smtClean="0"/>
            <a:t> </a:t>
          </a:r>
        </a:p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/>
            <a:t>of the </a:t>
          </a:r>
          <a:r>
            <a:rPr lang="es-ES" sz="700" kern="1200" dirty="0" err="1" smtClean="0"/>
            <a:t>mouth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535677" y="82669"/>
        <a:ext cx="534562" cy="399163"/>
      </dsp:txXfrm>
    </dsp:sp>
    <dsp:sp modelId="{ADF31E19-3513-45A4-9241-2348A1B01016}">
      <dsp:nvSpPr>
        <dsp:cNvPr id="0" name=""/>
        <dsp:cNvSpPr/>
      </dsp:nvSpPr>
      <dsp:spPr>
        <a:xfrm>
          <a:off x="2225520" y="343384"/>
          <a:ext cx="662476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600" kern="12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6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322537" y="426053"/>
        <a:ext cx="468442" cy="399163"/>
      </dsp:txXfrm>
    </dsp:sp>
    <dsp:sp modelId="{72EDB95F-2EA1-401F-AF4F-043134B29286}">
      <dsp:nvSpPr>
        <dsp:cNvPr id="0" name=""/>
        <dsp:cNvSpPr/>
      </dsp:nvSpPr>
      <dsp:spPr>
        <a:xfrm>
          <a:off x="1964786" y="1276789"/>
          <a:ext cx="720388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070284" y="1359458"/>
        <a:ext cx="509392" cy="399163"/>
      </dsp:txXfrm>
    </dsp:sp>
    <dsp:sp modelId="{614F53D1-4287-4607-B43A-D85A0FCF661E}">
      <dsp:nvSpPr>
        <dsp:cNvPr id="0" name=""/>
        <dsp:cNvSpPr/>
      </dsp:nvSpPr>
      <dsp:spPr>
        <a:xfrm>
          <a:off x="1620451" y="1470884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Light ID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03120" y="1553553"/>
        <a:ext cx="399163" cy="399163"/>
      </dsp:txXfrm>
    </dsp:sp>
    <dsp:sp modelId="{28C80B8C-BF19-4581-9A31-F40D8D8E3B6C}">
      <dsp:nvSpPr>
        <dsp:cNvPr id="0" name=""/>
        <dsp:cNvSpPr/>
      </dsp:nvSpPr>
      <dsp:spPr>
        <a:xfrm>
          <a:off x="1157584" y="1330264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6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sz="6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240253" y="1412933"/>
        <a:ext cx="399163" cy="399163"/>
      </dsp:txXfrm>
    </dsp:sp>
    <dsp:sp modelId="{DE96DFF5-015F-4F59-A3BB-E4577278E7CE}">
      <dsp:nvSpPr>
        <dsp:cNvPr id="0" name=""/>
        <dsp:cNvSpPr/>
      </dsp:nvSpPr>
      <dsp:spPr>
        <a:xfrm>
          <a:off x="887539" y="946601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970208" y="1029270"/>
        <a:ext cx="399163" cy="399163"/>
      </dsp:txXfrm>
    </dsp:sp>
    <dsp:sp modelId="{0D2FAAFB-6C18-4DA1-95E4-D13601D68C8A}">
      <dsp:nvSpPr>
        <dsp:cNvPr id="0" name=""/>
        <dsp:cNvSpPr/>
      </dsp:nvSpPr>
      <dsp:spPr>
        <a:xfrm>
          <a:off x="1979603" y="19366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Rou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062272" y="102035"/>
        <a:ext cx="399163" cy="399163"/>
      </dsp:txXfrm>
    </dsp:sp>
    <dsp:sp modelId="{CEE8EC5F-8DBF-44DF-8446-C990E41D50F6}">
      <dsp:nvSpPr>
        <dsp:cNvPr id="0" name=""/>
        <dsp:cNvSpPr/>
      </dsp:nvSpPr>
      <dsp:spPr>
        <a:xfrm>
          <a:off x="2223434" y="761899"/>
          <a:ext cx="671835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Dental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321822" y="844568"/>
        <a:ext cx="475059" cy="399163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347079" y="481310"/>
          <a:ext cx="1140929" cy="11409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514164" y="648395"/>
        <a:ext cx="806759" cy="806759"/>
      </dsp:txXfrm>
    </dsp:sp>
    <dsp:sp modelId="{8EF7DFA6-5C81-4E45-BE91-EE20E9FAE56A}">
      <dsp:nvSpPr>
        <dsp:cNvPr id="0" name=""/>
        <dsp:cNvSpPr/>
      </dsp:nvSpPr>
      <dsp:spPr>
        <a:xfrm>
          <a:off x="987760" y="229621"/>
          <a:ext cx="757417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98681" y="313164"/>
        <a:ext cx="535575" cy="403378"/>
      </dsp:txXfrm>
    </dsp:sp>
    <dsp:sp modelId="{8262EBD1-2017-484A-9727-5BB0DEA45C1E}">
      <dsp:nvSpPr>
        <dsp:cNvPr id="0" name=""/>
        <dsp:cNvSpPr/>
      </dsp:nvSpPr>
      <dsp:spPr>
        <a:xfrm>
          <a:off x="1403299" y="0"/>
          <a:ext cx="66947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/>
            <a:t>Auditive</a:t>
          </a:r>
          <a:r>
            <a:rPr lang="es-ES" sz="700" kern="1200" dirty="0" smtClean="0"/>
            <a:t> </a:t>
          </a:r>
          <a:r>
            <a:rPr lang="es-ES" sz="700" kern="1200" dirty="0" err="1" smtClean="0"/>
            <a:t>problem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501341" y="83543"/>
        <a:ext cx="473390" cy="403378"/>
      </dsp:txXfrm>
    </dsp:sp>
    <dsp:sp modelId="{ADF31E19-3513-45A4-9241-2348A1B01016}">
      <dsp:nvSpPr>
        <dsp:cNvPr id="0" name=""/>
        <dsp:cNvSpPr/>
      </dsp:nvSpPr>
      <dsp:spPr>
        <a:xfrm>
          <a:off x="1976743" y="43182"/>
          <a:ext cx="66947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074785" y="126725"/>
        <a:ext cx="473390" cy="403378"/>
      </dsp:txXfrm>
    </dsp:sp>
    <dsp:sp modelId="{72EDB95F-2EA1-401F-AF4F-043134B29286}">
      <dsp:nvSpPr>
        <dsp:cNvPr id="0" name=""/>
        <dsp:cNvSpPr/>
      </dsp:nvSpPr>
      <dsp:spPr>
        <a:xfrm>
          <a:off x="2308821" y="1063827"/>
          <a:ext cx="57046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to be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ated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392364" y="1147370"/>
        <a:ext cx="403378" cy="403378"/>
      </dsp:txXfrm>
    </dsp:sp>
    <dsp:sp modelId="{614F53D1-4287-4607-B43A-D85A0FCF661E}">
      <dsp:nvSpPr>
        <dsp:cNvPr id="0" name=""/>
        <dsp:cNvSpPr/>
      </dsp:nvSpPr>
      <dsp:spPr>
        <a:xfrm>
          <a:off x="1877040" y="1464919"/>
          <a:ext cx="73715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Use of </a:t>
          </a:r>
          <a:r>
            <a:rPr lang="es-ES" sz="6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ernative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ommun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.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tool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984994" y="1548462"/>
        <a:ext cx="521246" cy="403378"/>
      </dsp:txXfrm>
    </dsp:sp>
    <dsp:sp modelId="{28C80B8C-BF19-4581-9A31-F40D8D8E3B6C}">
      <dsp:nvSpPr>
        <dsp:cNvPr id="0" name=""/>
        <dsp:cNvSpPr/>
      </dsp:nvSpPr>
      <dsp:spPr>
        <a:xfrm>
          <a:off x="1311405" y="1453640"/>
          <a:ext cx="769476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24092" y="1537183"/>
        <a:ext cx="544102" cy="403378"/>
      </dsp:txXfrm>
    </dsp:sp>
    <dsp:sp modelId="{DE96DFF5-015F-4F59-A3BB-E4577278E7CE}">
      <dsp:nvSpPr>
        <dsp:cNvPr id="0" name=""/>
        <dsp:cNvSpPr/>
      </dsp:nvSpPr>
      <dsp:spPr>
        <a:xfrm>
          <a:off x="1021260" y="1126683"/>
          <a:ext cx="57046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104803" y="1210226"/>
        <a:ext cx="403378" cy="403378"/>
      </dsp:txXfrm>
    </dsp:sp>
    <dsp:sp modelId="{0D2FAAFB-6C18-4DA1-95E4-D13601D68C8A}">
      <dsp:nvSpPr>
        <dsp:cNvPr id="0" name=""/>
        <dsp:cNvSpPr/>
      </dsp:nvSpPr>
      <dsp:spPr>
        <a:xfrm>
          <a:off x="767622" y="615211"/>
          <a:ext cx="791879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83590" y="698754"/>
        <a:ext cx="559943" cy="403378"/>
      </dsp:txXfrm>
    </dsp:sp>
    <dsp:sp modelId="{CEE8EC5F-8DBF-44DF-8446-C990E41D50F6}">
      <dsp:nvSpPr>
        <dsp:cNvPr id="0" name=""/>
        <dsp:cNvSpPr/>
      </dsp:nvSpPr>
      <dsp:spPr>
        <a:xfrm>
          <a:off x="2322827" y="500708"/>
          <a:ext cx="570464" cy="570464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406370" y="584251"/>
        <a:ext cx="403378" cy="403378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267142" y="464720"/>
          <a:ext cx="1129003" cy="1129003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9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32481" y="630059"/>
        <a:ext cx="798325" cy="798325"/>
      </dsp:txXfrm>
    </dsp:sp>
    <dsp:sp modelId="{8EF7DFA6-5C81-4E45-BE91-EE20E9FAE56A}">
      <dsp:nvSpPr>
        <dsp:cNvPr id="0" name=""/>
        <dsp:cNvSpPr/>
      </dsp:nvSpPr>
      <dsp:spPr>
        <a:xfrm>
          <a:off x="2249518" y="465582"/>
          <a:ext cx="576503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333945" y="548251"/>
        <a:ext cx="407649" cy="399163"/>
      </dsp:txXfrm>
    </dsp:sp>
    <dsp:sp modelId="{7C5CB0D0-51D5-4107-B5AD-34AD4AEC6DB6}">
      <dsp:nvSpPr>
        <dsp:cNvPr id="0" name=""/>
        <dsp:cNvSpPr/>
      </dsp:nvSpPr>
      <dsp:spPr>
        <a:xfrm>
          <a:off x="2028137" y="1081569"/>
          <a:ext cx="787180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micrognath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143417" y="1164238"/>
        <a:ext cx="556620" cy="399163"/>
      </dsp:txXfrm>
    </dsp:sp>
    <dsp:sp modelId="{ADF31E19-3513-45A4-9241-2348A1B01016}">
      <dsp:nvSpPr>
        <dsp:cNvPr id="0" name=""/>
        <dsp:cNvSpPr/>
      </dsp:nvSpPr>
      <dsp:spPr>
        <a:xfrm>
          <a:off x="1514228" y="1412531"/>
          <a:ext cx="662476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nlarged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611245" y="1495200"/>
        <a:ext cx="468442" cy="399163"/>
      </dsp:txXfrm>
    </dsp:sp>
    <dsp:sp modelId="{0D2FAAFB-6C18-4DA1-95E4-D13601D68C8A}">
      <dsp:nvSpPr>
        <dsp:cNvPr id="0" name=""/>
        <dsp:cNvSpPr/>
      </dsp:nvSpPr>
      <dsp:spPr>
        <a:xfrm>
          <a:off x="1725119" y="135737"/>
          <a:ext cx="564501" cy="564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Rou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807788" y="218406"/>
        <a:ext cx="399163" cy="399163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645745" y="580278"/>
          <a:ext cx="1232192" cy="108311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826195" y="738897"/>
        <a:ext cx="871292" cy="765880"/>
      </dsp:txXfrm>
    </dsp:sp>
    <dsp:sp modelId="{8EF7DFA6-5C81-4E45-BE91-EE20E9FAE56A}">
      <dsp:nvSpPr>
        <dsp:cNvPr id="0" name=""/>
        <dsp:cNvSpPr/>
      </dsp:nvSpPr>
      <dsp:spPr>
        <a:xfrm>
          <a:off x="1178291" y="797916"/>
          <a:ext cx="773144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interact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with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 the </a:t>
          </a: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nvironment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291515" y="865957"/>
        <a:ext cx="546696" cy="328528"/>
      </dsp:txXfrm>
    </dsp:sp>
    <dsp:sp modelId="{9770CDF7-8417-4BBA-9FBC-F8390177E143}">
      <dsp:nvSpPr>
        <dsp:cNvPr id="0" name=""/>
        <dsp:cNvSpPr/>
      </dsp:nvSpPr>
      <dsp:spPr>
        <a:xfrm>
          <a:off x="1308919" y="468992"/>
          <a:ext cx="626294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00638" y="537033"/>
        <a:ext cx="442856" cy="328528"/>
      </dsp:txXfrm>
    </dsp:sp>
    <dsp:sp modelId="{8262EBD1-2017-484A-9727-5BB0DEA45C1E}">
      <dsp:nvSpPr>
        <dsp:cNvPr id="0" name=""/>
        <dsp:cNvSpPr/>
      </dsp:nvSpPr>
      <dsp:spPr>
        <a:xfrm>
          <a:off x="1798062" y="131614"/>
          <a:ext cx="545248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/>
            <a:t>Difficult</a:t>
          </a:r>
          <a:r>
            <a:rPr lang="es-ES" sz="900" kern="1200" dirty="0" smtClean="0"/>
            <a:t> to </a:t>
          </a:r>
          <a:r>
            <a:rPr lang="es-ES" sz="900" kern="1200" dirty="0" err="1" smtClean="0"/>
            <a:t>feed</a:t>
          </a:r>
          <a:endParaRPr lang="es-E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877912" y="199655"/>
        <a:ext cx="385548" cy="328528"/>
      </dsp:txXfrm>
    </dsp:sp>
    <dsp:sp modelId="{ADF31E19-3513-45A4-9241-2348A1B01016}">
      <dsp:nvSpPr>
        <dsp:cNvPr id="0" name=""/>
        <dsp:cNvSpPr/>
      </dsp:nvSpPr>
      <dsp:spPr>
        <a:xfrm>
          <a:off x="2469889" y="360021"/>
          <a:ext cx="545248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549739" y="428062"/>
        <a:ext cx="385548" cy="328528"/>
      </dsp:txXfrm>
    </dsp:sp>
    <dsp:sp modelId="{72EDB95F-2EA1-401F-AF4F-043134B29286}">
      <dsp:nvSpPr>
        <dsp:cNvPr id="0" name=""/>
        <dsp:cNvSpPr/>
      </dsp:nvSpPr>
      <dsp:spPr>
        <a:xfrm>
          <a:off x="2652712" y="1205315"/>
          <a:ext cx="659179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749247" y="1273356"/>
        <a:ext cx="466109" cy="328528"/>
      </dsp:txXfrm>
    </dsp:sp>
    <dsp:sp modelId="{614F53D1-4287-4607-B43A-D85A0FCF661E}">
      <dsp:nvSpPr>
        <dsp:cNvPr id="0" name=""/>
        <dsp:cNvSpPr/>
      </dsp:nvSpPr>
      <dsp:spPr>
        <a:xfrm>
          <a:off x="2432379" y="1482244"/>
          <a:ext cx="464610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500420" y="1550285"/>
        <a:ext cx="328528" cy="328528"/>
      </dsp:txXfrm>
    </dsp:sp>
    <dsp:sp modelId="{28C80B8C-BF19-4581-9A31-F40D8D8E3B6C}">
      <dsp:nvSpPr>
        <dsp:cNvPr id="0" name=""/>
        <dsp:cNvSpPr/>
      </dsp:nvSpPr>
      <dsp:spPr>
        <a:xfrm>
          <a:off x="1953352" y="1542810"/>
          <a:ext cx="666460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050953" y="1610851"/>
        <a:ext cx="471258" cy="328528"/>
      </dsp:txXfrm>
    </dsp:sp>
    <dsp:sp modelId="{DE96DFF5-015F-4F59-A3BB-E4577278E7CE}">
      <dsp:nvSpPr>
        <dsp:cNvPr id="0" name=""/>
        <dsp:cNvSpPr/>
      </dsp:nvSpPr>
      <dsp:spPr>
        <a:xfrm>
          <a:off x="1535341" y="1542819"/>
          <a:ext cx="590082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Larynx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glotti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621757" y="1610860"/>
        <a:ext cx="417250" cy="328528"/>
      </dsp:txXfrm>
    </dsp:sp>
    <dsp:sp modelId="{0D2FAAFB-6C18-4DA1-95E4-D13601D68C8A}">
      <dsp:nvSpPr>
        <dsp:cNvPr id="0" name=""/>
        <dsp:cNvSpPr/>
      </dsp:nvSpPr>
      <dsp:spPr>
        <a:xfrm>
          <a:off x="1012829" y="1237382"/>
          <a:ext cx="791496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sm</a:t>
          </a:r>
          <a:endParaRPr lang="es-ES" sz="6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128741" y="1305423"/>
        <a:ext cx="559672" cy="328528"/>
      </dsp:txXfrm>
    </dsp:sp>
    <dsp:sp modelId="{CEE8EC5F-8DBF-44DF-8446-C990E41D50F6}">
      <dsp:nvSpPr>
        <dsp:cNvPr id="0" name=""/>
        <dsp:cNvSpPr/>
      </dsp:nvSpPr>
      <dsp:spPr>
        <a:xfrm>
          <a:off x="1280354" y="204658"/>
          <a:ext cx="665233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ar</a:t>
          </a:r>
          <a:endParaRPr lang="es-ES" sz="700" kern="1200" dirty="0" smtClean="0">
            <a:latin typeface="Arial" panose="020B0604020202020204" pitchFamily="34" charset="0"/>
            <a:cs typeface="Arial" panose="020B0604020202020204" pitchFamily="34" charset="0"/>
          </a:endParaRPr>
        </a:p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377775" y="272699"/>
        <a:ext cx="470391" cy="328528"/>
      </dsp:txXfrm>
    </dsp:sp>
    <dsp:sp modelId="{54FA25BC-2D34-48BC-89C3-CEA2C1AB809D}">
      <dsp:nvSpPr>
        <dsp:cNvPr id="0" name=""/>
        <dsp:cNvSpPr/>
      </dsp:nvSpPr>
      <dsp:spPr>
        <a:xfrm>
          <a:off x="2194059" y="0"/>
          <a:ext cx="651722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Join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islocation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289501" y="68041"/>
        <a:ext cx="460838" cy="328528"/>
      </dsp:txXfrm>
    </dsp:sp>
    <dsp:sp modelId="{1038236E-81C7-4FE6-9BD5-0602F9F4F3AE}">
      <dsp:nvSpPr>
        <dsp:cNvPr id="0" name=""/>
        <dsp:cNvSpPr/>
      </dsp:nvSpPr>
      <dsp:spPr>
        <a:xfrm>
          <a:off x="2876631" y="468990"/>
          <a:ext cx="652154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972137" y="537031"/>
        <a:ext cx="461142" cy="328528"/>
      </dsp:txXfrm>
    </dsp:sp>
    <dsp:sp modelId="{A92DD552-EE5E-480B-8C78-9BEF90C23308}">
      <dsp:nvSpPr>
        <dsp:cNvPr id="0" name=""/>
        <dsp:cNvSpPr/>
      </dsp:nvSpPr>
      <dsp:spPr>
        <a:xfrm>
          <a:off x="2651797" y="764120"/>
          <a:ext cx="788090" cy="46461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amily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member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no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longer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work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for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ar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767210" y="832161"/>
        <a:ext cx="557264" cy="328528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602907" y="474699"/>
          <a:ext cx="1125258" cy="112525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67697" y="639489"/>
        <a:ext cx="795678" cy="795678"/>
      </dsp:txXfrm>
    </dsp:sp>
    <dsp:sp modelId="{8EF7DFA6-5C81-4E45-BE91-EE20E9FAE56A}">
      <dsp:nvSpPr>
        <dsp:cNvPr id="0" name=""/>
        <dsp:cNvSpPr/>
      </dsp:nvSpPr>
      <dsp:spPr>
        <a:xfrm>
          <a:off x="1269670" y="226467"/>
          <a:ext cx="704721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otonia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372874" y="308862"/>
        <a:ext cx="498313" cy="397839"/>
      </dsp:txXfrm>
    </dsp:sp>
    <dsp:sp modelId="{8262EBD1-2017-484A-9727-5BB0DEA45C1E}">
      <dsp:nvSpPr>
        <dsp:cNvPr id="0" name=""/>
        <dsp:cNvSpPr/>
      </dsp:nvSpPr>
      <dsp:spPr>
        <a:xfrm>
          <a:off x="1658355" y="0"/>
          <a:ext cx="660279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iffiul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to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eed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55051" y="82395"/>
        <a:ext cx="466887" cy="397839"/>
      </dsp:txXfrm>
    </dsp:sp>
    <dsp:sp modelId="{ADF31E19-3513-45A4-9241-2348A1B01016}">
      <dsp:nvSpPr>
        <dsp:cNvPr id="0" name=""/>
        <dsp:cNvSpPr/>
      </dsp:nvSpPr>
      <dsp:spPr>
        <a:xfrm>
          <a:off x="2223923" y="42589"/>
          <a:ext cx="660279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Narrow nasal bridg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320619" y="124984"/>
        <a:ext cx="466887" cy="397839"/>
      </dsp:txXfrm>
    </dsp:sp>
    <dsp:sp modelId="{72EDB95F-2EA1-401F-AF4F-043134B29286}">
      <dsp:nvSpPr>
        <dsp:cNvPr id="0" name=""/>
        <dsp:cNvSpPr/>
      </dsp:nvSpPr>
      <dsp:spPr>
        <a:xfrm>
          <a:off x="2551440" y="1049216"/>
          <a:ext cx="562629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6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600" kern="1200" dirty="0" smtClean="0">
              <a:latin typeface="Arial" panose="020B0604020202020204" pitchFamily="34" charset="0"/>
              <a:cs typeface="Arial" panose="020B0604020202020204" pitchFamily="34" charset="0"/>
            </a:rPr>
            <a:t> to be </a:t>
          </a:r>
          <a:r>
            <a:rPr lang="es-ES" sz="6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ated</a:t>
          </a:r>
          <a:r>
            <a:rPr lang="es-ES" sz="6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6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6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633835" y="1131611"/>
        <a:ext cx="397839" cy="397839"/>
      </dsp:txXfrm>
    </dsp:sp>
    <dsp:sp modelId="{614F53D1-4287-4607-B43A-D85A0FCF661E}">
      <dsp:nvSpPr>
        <dsp:cNvPr id="0" name=""/>
        <dsp:cNvSpPr/>
      </dsp:nvSpPr>
      <dsp:spPr>
        <a:xfrm>
          <a:off x="2140994" y="1444798"/>
          <a:ext cx="696220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Use of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ernative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ommun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.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tool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242953" y="1527193"/>
        <a:ext cx="492302" cy="397839"/>
      </dsp:txXfrm>
    </dsp:sp>
    <dsp:sp modelId="{28C80B8C-BF19-4581-9A31-F40D8D8E3B6C}">
      <dsp:nvSpPr>
        <dsp:cNvPr id="0" name=""/>
        <dsp:cNvSpPr/>
      </dsp:nvSpPr>
      <dsp:spPr>
        <a:xfrm>
          <a:off x="1618014" y="1433674"/>
          <a:ext cx="658326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ee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and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eration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14424" y="1516069"/>
        <a:ext cx="465506" cy="397839"/>
      </dsp:txXfrm>
    </dsp:sp>
    <dsp:sp modelId="{DE96DFF5-015F-4F59-A3BB-E4577278E7CE}">
      <dsp:nvSpPr>
        <dsp:cNvPr id="0" name=""/>
        <dsp:cNvSpPr/>
      </dsp:nvSpPr>
      <dsp:spPr>
        <a:xfrm>
          <a:off x="1269672" y="1111208"/>
          <a:ext cx="586411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Larynx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and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glotti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lt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355550" y="1193603"/>
        <a:ext cx="414655" cy="397839"/>
      </dsp:txXfrm>
    </dsp:sp>
    <dsp:sp modelId="{0D2FAAFB-6C18-4DA1-95E4-D13601D68C8A}">
      <dsp:nvSpPr>
        <dsp:cNvPr id="0" name=""/>
        <dsp:cNvSpPr/>
      </dsp:nvSpPr>
      <dsp:spPr>
        <a:xfrm>
          <a:off x="1065062" y="606761"/>
          <a:ext cx="713695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Dental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nomalies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169580" y="689156"/>
        <a:ext cx="504659" cy="397839"/>
      </dsp:txXfrm>
    </dsp:sp>
    <dsp:sp modelId="{CEE8EC5F-8DBF-44DF-8446-C990E41D50F6}">
      <dsp:nvSpPr>
        <dsp:cNvPr id="0" name=""/>
        <dsp:cNvSpPr/>
      </dsp:nvSpPr>
      <dsp:spPr>
        <a:xfrm>
          <a:off x="2565253" y="493831"/>
          <a:ext cx="562629" cy="562629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ephalic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upport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647648" y="576226"/>
        <a:ext cx="397839" cy="397839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580323" y="458337"/>
          <a:ext cx="1113496" cy="1113496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High-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pitched</a:t>
          </a:r>
          <a:r>
            <a:rPr lang="es-ES" sz="9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9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cry</a:t>
          </a:r>
          <a:endParaRPr lang="es-ES" sz="9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43391" y="621405"/>
        <a:ext cx="787360" cy="787360"/>
      </dsp:txXfrm>
    </dsp:sp>
    <dsp:sp modelId="{8EF7DFA6-5C81-4E45-BE91-EE20E9FAE56A}">
      <dsp:nvSpPr>
        <dsp:cNvPr id="0" name=""/>
        <dsp:cNvSpPr/>
      </dsp:nvSpPr>
      <dsp:spPr>
        <a:xfrm>
          <a:off x="2471769" y="456505"/>
          <a:ext cx="556748" cy="55674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8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izures</a:t>
          </a:r>
          <a:endParaRPr lang="es-ES" sz="8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553303" y="538039"/>
        <a:ext cx="393680" cy="393680"/>
      </dsp:txXfrm>
    </dsp:sp>
    <dsp:sp modelId="{7C5CB0D0-51D5-4107-B5AD-34AD4AEC6DB6}">
      <dsp:nvSpPr>
        <dsp:cNvPr id="0" name=""/>
        <dsp:cNvSpPr/>
      </dsp:nvSpPr>
      <dsp:spPr>
        <a:xfrm>
          <a:off x="2409723" y="1066713"/>
          <a:ext cx="618652" cy="55674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8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ASD</a:t>
          </a:r>
          <a:endParaRPr lang="es-ES" sz="8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500322" y="1148247"/>
        <a:ext cx="437454" cy="393680"/>
      </dsp:txXfrm>
    </dsp:sp>
    <dsp:sp modelId="{ADF31E19-3513-45A4-9241-2348A1B01016}">
      <dsp:nvSpPr>
        <dsp:cNvPr id="0" name=""/>
        <dsp:cNvSpPr/>
      </dsp:nvSpPr>
      <dsp:spPr>
        <a:xfrm>
          <a:off x="1824015" y="1393129"/>
          <a:ext cx="653377" cy="55674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8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nlarged</a:t>
          </a:r>
          <a:r>
            <a:rPr lang="es-ES" sz="8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8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face</a:t>
          </a:r>
          <a:endParaRPr lang="es-E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919700" y="1474663"/>
        <a:ext cx="462007" cy="393680"/>
      </dsp:txXfrm>
    </dsp:sp>
    <dsp:sp modelId="{0D2FAAFB-6C18-4DA1-95E4-D13601D68C8A}">
      <dsp:nvSpPr>
        <dsp:cNvPr id="0" name=""/>
        <dsp:cNvSpPr/>
      </dsp:nvSpPr>
      <dsp:spPr>
        <a:xfrm>
          <a:off x="1728386" y="70114"/>
          <a:ext cx="556748" cy="556748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10160" tIns="10160" rIns="10160" bIns="1016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800" kern="1200" dirty="0" smtClean="0">
              <a:latin typeface="Arial" panose="020B0604020202020204" pitchFamily="34" charset="0"/>
              <a:cs typeface="Arial" panose="020B0604020202020204" pitchFamily="34" charset="0"/>
            </a:rPr>
            <a:t>Short philtrum</a:t>
          </a:r>
          <a:endParaRPr lang="es-E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809920" y="151648"/>
        <a:ext cx="393680" cy="393680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313150" y="441767"/>
          <a:ext cx="1073240" cy="107324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70322" y="598939"/>
        <a:ext cx="758896" cy="758896"/>
      </dsp:txXfrm>
    </dsp:sp>
    <dsp:sp modelId="{8EF7DFA6-5C81-4E45-BE91-EE20E9FAE56A}">
      <dsp:nvSpPr>
        <dsp:cNvPr id="0" name=""/>
        <dsp:cNvSpPr/>
      </dsp:nvSpPr>
      <dsp:spPr>
        <a:xfrm>
          <a:off x="863699" y="833133"/>
          <a:ext cx="749127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ypertelorim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 (-)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973406" y="911719"/>
        <a:ext cx="529713" cy="379448"/>
      </dsp:txXfrm>
    </dsp:sp>
    <dsp:sp modelId="{AB3CAD86-439D-450E-8B31-7A2D97EFB1C6}">
      <dsp:nvSpPr>
        <dsp:cNvPr id="0" name=""/>
        <dsp:cNvSpPr/>
      </dsp:nvSpPr>
      <dsp:spPr>
        <a:xfrm>
          <a:off x="1458203" y="18150"/>
          <a:ext cx="957974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To </a:t>
          </a: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have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dditional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uplication</a:t>
          </a: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598495" y="96736"/>
        <a:ext cx="677390" cy="379448"/>
      </dsp:txXfrm>
    </dsp:sp>
    <dsp:sp modelId="{8262EBD1-2017-484A-9727-5BB0DEA45C1E}">
      <dsp:nvSpPr>
        <dsp:cNvPr id="0" name=""/>
        <dsp:cNvSpPr/>
      </dsp:nvSpPr>
      <dsp:spPr>
        <a:xfrm>
          <a:off x="2086733" y="379284"/>
          <a:ext cx="629756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Able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to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walk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aided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178959" y="457870"/>
        <a:ext cx="445304" cy="379448"/>
      </dsp:txXfrm>
    </dsp:sp>
    <dsp:sp modelId="{614F53D1-4287-4607-B43A-D85A0FCF661E}">
      <dsp:nvSpPr>
        <dsp:cNvPr id="0" name=""/>
        <dsp:cNvSpPr/>
      </dsp:nvSpPr>
      <dsp:spPr>
        <a:xfrm>
          <a:off x="971918" y="327658"/>
          <a:ext cx="780675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Normal EEG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86245" y="406244"/>
        <a:ext cx="552021" cy="379448"/>
      </dsp:txXfrm>
    </dsp:sp>
    <dsp:sp modelId="{DE96DFF5-015F-4F59-A3BB-E4577278E7CE}">
      <dsp:nvSpPr>
        <dsp:cNvPr id="0" name=""/>
        <dsp:cNvSpPr/>
      </dsp:nvSpPr>
      <dsp:spPr>
        <a:xfrm>
          <a:off x="2084838" y="904410"/>
          <a:ext cx="761480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Can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read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/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write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196354" y="982996"/>
        <a:ext cx="538448" cy="379448"/>
      </dsp:txXfrm>
    </dsp:sp>
    <dsp:sp modelId="{0D2FAAFB-6C18-4DA1-95E4-D13601D68C8A}">
      <dsp:nvSpPr>
        <dsp:cNvPr id="0" name=""/>
        <dsp:cNvSpPr/>
      </dsp:nvSpPr>
      <dsp:spPr>
        <a:xfrm>
          <a:off x="1630299" y="1263517"/>
          <a:ext cx="774767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Use </a:t>
          </a: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 (-)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743761" y="1342103"/>
        <a:ext cx="547843" cy="379448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391857" y="398084"/>
          <a:ext cx="1073241" cy="107324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5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549030" y="555257"/>
        <a:ext cx="758895" cy="758895"/>
      </dsp:txXfrm>
    </dsp:sp>
    <dsp:sp modelId="{614F53D1-4287-4607-B43A-D85A0FCF661E}">
      <dsp:nvSpPr>
        <dsp:cNvPr id="0" name=""/>
        <dsp:cNvSpPr/>
      </dsp:nvSpPr>
      <dsp:spPr>
        <a:xfrm>
          <a:off x="1165239" y="0"/>
          <a:ext cx="1232596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Epicanthu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345749" y="78586"/>
        <a:ext cx="871576" cy="379448"/>
      </dsp:txXfrm>
    </dsp:sp>
    <dsp:sp modelId="{DE96DFF5-015F-4F59-A3BB-E4577278E7CE}">
      <dsp:nvSpPr>
        <dsp:cNvPr id="0" name=""/>
        <dsp:cNvSpPr/>
      </dsp:nvSpPr>
      <dsp:spPr>
        <a:xfrm>
          <a:off x="1473739" y="1398045"/>
          <a:ext cx="905563" cy="53662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Diapers</a:t>
          </a: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(-)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606356" y="1476631"/>
        <a:ext cx="640329" cy="379448"/>
      </dsp:txXfrm>
    </dsp:sp>
  </dsp:spTree>
</dsp:drawing>
</file>

<file path=ppt/diagrams/drawing9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7869398-6C49-4AB9-8205-101672020437}">
      <dsp:nvSpPr>
        <dsp:cNvPr id="0" name=""/>
        <dsp:cNvSpPr/>
      </dsp:nvSpPr>
      <dsp:spPr>
        <a:xfrm>
          <a:off x="1288694" y="461558"/>
          <a:ext cx="1188501" cy="1188501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Short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understandable</a:t>
          </a:r>
          <a:r>
            <a:rPr lang="es-ES" sz="700" b="1" kern="120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s-ES" sz="700" b="1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ntences</a:t>
          </a:r>
          <a:endParaRPr lang="es-ES" sz="7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462746" y="635610"/>
        <a:ext cx="840397" cy="840397"/>
      </dsp:txXfrm>
    </dsp:sp>
    <dsp:sp modelId="{8EF7DFA6-5C81-4E45-BE91-EE20E9FAE56A}">
      <dsp:nvSpPr>
        <dsp:cNvPr id="0" name=""/>
        <dsp:cNvSpPr/>
      </dsp:nvSpPr>
      <dsp:spPr>
        <a:xfrm>
          <a:off x="2315449" y="638400"/>
          <a:ext cx="594250" cy="59425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smtClean="0">
              <a:latin typeface="Arial" panose="020B0604020202020204" pitchFamily="34" charset="0"/>
              <a:cs typeface="Arial" panose="020B0604020202020204" pitchFamily="34" charset="0"/>
            </a:rPr>
            <a:t>ASD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402475" y="725426"/>
        <a:ext cx="420198" cy="420198"/>
      </dsp:txXfrm>
    </dsp:sp>
    <dsp:sp modelId="{7C5CB0D0-51D5-4107-B5AD-34AD4AEC6DB6}">
      <dsp:nvSpPr>
        <dsp:cNvPr id="0" name=""/>
        <dsp:cNvSpPr/>
      </dsp:nvSpPr>
      <dsp:spPr>
        <a:xfrm>
          <a:off x="1813797" y="1340607"/>
          <a:ext cx="660325" cy="59425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b="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eizures</a:t>
          </a:r>
          <a:endParaRPr lang="es-ES" sz="700" b="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910499" y="1427633"/>
        <a:ext cx="466921" cy="420198"/>
      </dsp:txXfrm>
    </dsp:sp>
    <dsp:sp modelId="{ADF31E19-3513-45A4-9241-2348A1B01016}">
      <dsp:nvSpPr>
        <dsp:cNvPr id="0" name=""/>
        <dsp:cNvSpPr/>
      </dsp:nvSpPr>
      <dsp:spPr>
        <a:xfrm>
          <a:off x="957468" y="1196794"/>
          <a:ext cx="697388" cy="59425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s-ES" sz="700" kern="1200" dirty="0" smtClean="0">
              <a:latin typeface="Arial" panose="020B0604020202020204" pitchFamily="34" charset="0"/>
              <a:cs typeface="Arial" panose="020B0604020202020204" pitchFamily="34" charset="0"/>
            </a:rPr>
            <a:t>Short philtrum</a:t>
          </a:r>
          <a:endParaRPr lang="es-ES" sz="7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59598" y="1283820"/>
        <a:ext cx="493128" cy="4201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layout9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9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423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7265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5033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984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3675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95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4831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5319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658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806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4387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867C4-B282-4A28-9462-58CDFF1F00E6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35B37-FF6B-480C-9895-C661B95468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4004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diagramLayout" Target="../diagrams/layout3.xml"/><Relationship Id="rId18" Type="http://schemas.openxmlformats.org/officeDocument/2006/relationships/diagramLayout" Target="../diagrams/layout4.xml"/><Relationship Id="rId26" Type="http://schemas.microsoft.com/office/2007/relationships/diagramDrawing" Target="../diagrams/drawing5.xml"/><Relationship Id="rId39" Type="http://schemas.openxmlformats.org/officeDocument/2006/relationships/diagramQuickStyle" Target="../diagrams/quickStyle8.xml"/><Relationship Id="rId21" Type="http://schemas.microsoft.com/office/2007/relationships/diagramDrawing" Target="../diagrams/drawing4.xml"/><Relationship Id="rId34" Type="http://schemas.openxmlformats.org/officeDocument/2006/relationships/diagramQuickStyle" Target="../diagrams/quickStyle7.xml"/><Relationship Id="rId42" Type="http://schemas.openxmlformats.org/officeDocument/2006/relationships/diagramData" Target="../diagrams/data9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6" Type="http://schemas.microsoft.com/office/2007/relationships/diagramDrawing" Target="../diagrams/drawing3.xml"/><Relationship Id="rId29" Type="http://schemas.openxmlformats.org/officeDocument/2006/relationships/diagramQuickStyle" Target="../diagrams/quickStyle6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24" Type="http://schemas.openxmlformats.org/officeDocument/2006/relationships/diagramQuickStyle" Target="../diagrams/quickStyle5.xml"/><Relationship Id="rId32" Type="http://schemas.openxmlformats.org/officeDocument/2006/relationships/diagramData" Target="../diagrams/data7.xml"/><Relationship Id="rId37" Type="http://schemas.openxmlformats.org/officeDocument/2006/relationships/diagramData" Target="../diagrams/data8.xml"/><Relationship Id="rId40" Type="http://schemas.openxmlformats.org/officeDocument/2006/relationships/diagramColors" Target="../diagrams/colors8.xml"/><Relationship Id="rId45" Type="http://schemas.openxmlformats.org/officeDocument/2006/relationships/diagramColors" Target="../diagrams/colors9.xml"/><Relationship Id="rId5" Type="http://schemas.openxmlformats.org/officeDocument/2006/relationships/diagramColors" Target="../diagrams/colors1.xml"/><Relationship Id="rId15" Type="http://schemas.openxmlformats.org/officeDocument/2006/relationships/diagramColors" Target="../diagrams/colors3.xml"/><Relationship Id="rId23" Type="http://schemas.openxmlformats.org/officeDocument/2006/relationships/diagramLayout" Target="../diagrams/layout5.xml"/><Relationship Id="rId28" Type="http://schemas.openxmlformats.org/officeDocument/2006/relationships/diagramLayout" Target="../diagrams/layout6.xml"/><Relationship Id="rId36" Type="http://schemas.microsoft.com/office/2007/relationships/diagramDrawing" Target="../diagrams/drawing7.xml"/><Relationship Id="rId10" Type="http://schemas.openxmlformats.org/officeDocument/2006/relationships/diagramColors" Target="../diagrams/colors2.xml"/><Relationship Id="rId19" Type="http://schemas.openxmlformats.org/officeDocument/2006/relationships/diagramQuickStyle" Target="../diagrams/quickStyle4.xml"/><Relationship Id="rId31" Type="http://schemas.microsoft.com/office/2007/relationships/diagramDrawing" Target="../diagrams/drawing6.xml"/><Relationship Id="rId44" Type="http://schemas.openxmlformats.org/officeDocument/2006/relationships/diagramQuickStyle" Target="../diagrams/quickStyle9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QuickStyle" Target="../diagrams/quickStyle3.xml"/><Relationship Id="rId22" Type="http://schemas.openxmlformats.org/officeDocument/2006/relationships/diagramData" Target="../diagrams/data5.xml"/><Relationship Id="rId27" Type="http://schemas.openxmlformats.org/officeDocument/2006/relationships/diagramData" Target="../diagrams/data6.xml"/><Relationship Id="rId30" Type="http://schemas.openxmlformats.org/officeDocument/2006/relationships/diagramColors" Target="../diagrams/colors6.xml"/><Relationship Id="rId35" Type="http://schemas.openxmlformats.org/officeDocument/2006/relationships/diagramColors" Target="../diagrams/colors7.xml"/><Relationship Id="rId43" Type="http://schemas.openxmlformats.org/officeDocument/2006/relationships/diagramLayout" Target="../diagrams/layout9.xml"/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12" Type="http://schemas.openxmlformats.org/officeDocument/2006/relationships/diagramData" Target="../diagrams/data3.xml"/><Relationship Id="rId17" Type="http://schemas.openxmlformats.org/officeDocument/2006/relationships/diagramData" Target="../diagrams/data4.xml"/><Relationship Id="rId25" Type="http://schemas.openxmlformats.org/officeDocument/2006/relationships/diagramColors" Target="../diagrams/colors5.xml"/><Relationship Id="rId33" Type="http://schemas.openxmlformats.org/officeDocument/2006/relationships/diagramLayout" Target="../diagrams/layout7.xml"/><Relationship Id="rId38" Type="http://schemas.openxmlformats.org/officeDocument/2006/relationships/diagramLayout" Target="../diagrams/layout8.xml"/><Relationship Id="rId46" Type="http://schemas.microsoft.com/office/2007/relationships/diagramDrawing" Target="../diagrams/drawing9.xml"/><Relationship Id="rId20" Type="http://schemas.openxmlformats.org/officeDocument/2006/relationships/diagramColors" Target="../diagrams/colors4.xml"/><Relationship Id="rId41" Type="http://schemas.microsoft.com/office/2007/relationships/diagramDrawing" Target="../diagrams/drawing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CuadroTexto 55"/>
          <p:cNvSpPr txBox="1"/>
          <p:nvPr/>
        </p:nvSpPr>
        <p:spPr>
          <a:xfrm>
            <a:off x="6710524" y="76344"/>
            <a:ext cx="1600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b) 5p </a:t>
            </a:r>
            <a:r>
              <a:rPr lang="es-ES" sz="1200" b="1" dirty="0" smtClean="0"/>
              <a:t>simple </a:t>
            </a:r>
            <a:r>
              <a:rPr lang="es-ES" sz="1200" b="1" dirty="0" err="1" smtClean="0"/>
              <a:t>deletions</a:t>
            </a:r>
            <a:endParaRPr lang="es-ES" sz="1200" b="1" dirty="0"/>
          </a:p>
        </p:txBody>
      </p:sp>
      <p:sp>
        <p:nvSpPr>
          <p:cNvPr id="57" name="CuadroTexto 56"/>
          <p:cNvSpPr txBox="1"/>
          <p:nvPr/>
        </p:nvSpPr>
        <p:spPr>
          <a:xfrm>
            <a:off x="9243609" y="-2211"/>
            <a:ext cx="1930145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smtClean="0"/>
              <a:t>c) 5p </a:t>
            </a:r>
            <a:r>
              <a:rPr lang="es-ES" sz="1100" b="1" dirty="0" err="1" smtClean="0"/>
              <a:t>deletions</a:t>
            </a:r>
            <a:endParaRPr lang="es-ES" sz="1100" b="1" dirty="0" smtClean="0"/>
          </a:p>
          <a:p>
            <a:pPr algn="ctr"/>
            <a:r>
              <a:rPr lang="es-ES" sz="1100" b="1" dirty="0" smtClean="0"/>
              <a:t>+ </a:t>
            </a:r>
            <a:r>
              <a:rPr lang="es-ES" sz="1100" b="1" dirty="0" err="1" smtClean="0"/>
              <a:t>additional</a:t>
            </a:r>
            <a:r>
              <a:rPr lang="es-ES" sz="1100" b="1" dirty="0" smtClean="0"/>
              <a:t> </a:t>
            </a:r>
            <a:r>
              <a:rPr lang="es-ES" sz="1200" b="1" dirty="0" err="1" smtClean="0"/>
              <a:t>rearrangements</a:t>
            </a:r>
            <a:endParaRPr lang="es-ES" sz="1100" b="1" dirty="0"/>
          </a:p>
        </p:txBody>
      </p:sp>
      <p:sp>
        <p:nvSpPr>
          <p:cNvPr id="60" name="CuadroTexto 59"/>
          <p:cNvSpPr txBox="1"/>
          <p:nvPr/>
        </p:nvSpPr>
        <p:spPr>
          <a:xfrm>
            <a:off x="4028245" y="104818"/>
            <a:ext cx="12210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a) </a:t>
            </a:r>
            <a:r>
              <a:rPr lang="es-ES" sz="1200" b="1" dirty="0" err="1" smtClean="0"/>
              <a:t>Whole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cohort</a:t>
            </a:r>
            <a:endParaRPr lang="es-ES" sz="1200" b="1" dirty="0"/>
          </a:p>
        </p:txBody>
      </p:sp>
      <p:grpSp>
        <p:nvGrpSpPr>
          <p:cNvPr id="81" name="Grupo 80"/>
          <p:cNvGrpSpPr/>
          <p:nvPr/>
        </p:nvGrpSpPr>
        <p:grpSpPr>
          <a:xfrm>
            <a:off x="2247207" y="67635"/>
            <a:ext cx="10172610" cy="6735360"/>
            <a:chOff x="1119155" y="32962"/>
            <a:chExt cx="10172610" cy="6735360"/>
          </a:xfrm>
        </p:grpSpPr>
        <p:grpSp>
          <p:nvGrpSpPr>
            <p:cNvPr id="71" name="Grupo 70"/>
            <p:cNvGrpSpPr/>
            <p:nvPr/>
          </p:nvGrpSpPr>
          <p:grpSpPr>
            <a:xfrm>
              <a:off x="1533252" y="248511"/>
              <a:ext cx="9318006" cy="2130788"/>
              <a:chOff x="-1236899" y="303715"/>
              <a:chExt cx="14505687" cy="3093365"/>
            </a:xfrm>
          </p:grpSpPr>
          <p:graphicFrame>
            <p:nvGraphicFramePr>
              <p:cNvPr id="4" name="Diagrama 3"/>
              <p:cNvGraphicFramePr/>
              <p:nvPr>
                <p:extLst>
                  <p:ext uri="{D42A27DB-BD31-4B8C-83A1-F6EECF244321}">
                    <p14:modId xmlns:p14="http://schemas.microsoft.com/office/powerpoint/2010/main" val="1564508051"/>
                  </p:ext>
                </p:extLst>
              </p:nvPr>
            </p:nvGraphicFramePr>
            <p:xfrm>
              <a:off x="-1236899" y="442215"/>
              <a:ext cx="5977468" cy="2954865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graphicFrame>
            <p:nvGraphicFramePr>
              <p:cNvPr id="54" name="Diagrama 53"/>
              <p:cNvGraphicFramePr/>
              <p:nvPr>
                <p:extLst>
                  <p:ext uri="{D42A27DB-BD31-4B8C-83A1-F6EECF244321}">
                    <p14:modId xmlns:p14="http://schemas.microsoft.com/office/powerpoint/2010/main" val="1996596197"/>
                  </p:ext>
                </p:extLst>
              </p:nvPr>
            </p:nvGraphicFramePr>
            <p:xfrm>
              <a:off x="3382650" y="343926"/>
              <a:ext cx="5977467" cy="2954866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7" r:lo="rId8" r:qs="rId9" r:cs="rId10"/>
              </a:graphicData>
            </a:graphic>
          </p:graphicFrame>
          <p:graphicFrame>
            <p:nvGraphicFramePr>
              <p:cNvPr id="55" name="Diagrama 54"/>
              <p:cNvGraphicFramePr/>
              <p:nvPr>
                <p:extLst>
                  <p:ext uri="{D42A27DB-BD31-4B8C-83A1-F6EECF244321}">
                    <p14:modId xmlns:p14="http://schemas.microsoft.com/office/powerpoint/2010/main" val="3559860632"/>
                  </p:ext>
                </p:extLst>
              </p:nvPr>
            </p:nvGraphicFramePr>
            <p:xfrm>
              <a:off x="7291320" y="325934"/>
              <a:ext cx="5977468" cy="2954867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12" r:lo="rId13" r:qs="rId14" r:cs="rId15"/>
              </a:graphicData>
            </a:graphic>
          </p:graphicFrame>
          <p:sp>
            <p:nvSpPr>
              <p:cNvPr id="58" name="Rectángulo 57"/>
              <p:cNvSpPr/>
              <p:nvPr/>
            </p:nvSpPr>
            <p:spPr>
              <a:xfrm>
                <a:off x="7323117" y="303715"/>
                <a:ext cx="781577" cy="402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/>
                  <a:t>n=43</a:t>
                </a:r>
                <a:endParaRPr lang="es-ES" sz="1200" b="1" dirty="0"/>
              </a:p>
            </p:txBody>
          </p:sp>
          <p:sp>
            <p:nvSpPr>
              <p:cNvPr id="59" name="Rectángulo 58"/>
              <p:cNvSpPr/>
              <p:nvPr/>
            </p:nvSpPr>
            <p:spPr>
              <a:xfrm>
                <a:off x="10990933" y="366757"/>
                <a:ext cx="781577" cy="402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/>
                  <a:t>n=27</a:t>
                </a:r>
                <a:endParaRPr lang="es-ES" sz="1200" b="1" dirty="0"/>
              </a:p>
            </p:txBody>
          </p:sp>
          <p:sp>
            <p:nvSpPr>
              <p:cNvPr id="61" name="Rectángulo 60"/>
              <p:cNvSpPr/>
              <p:nvPr/>
            </p:nvSpPr>
            <p:spPr>
              <a:xfrm>
                <a:off x="2847209" y="352713"/>
                <a:ext cx="50206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/>
                  <a:t>n=70</a:t>
                </a:r>
                <a:endParaRPr lang="es-ES" sz="1200" b="1" dirty="0"/>
              </a:p>
            </p:txBody>
          </p:sp>
        </p:grpSp>
        <p:grpSp>
          <p:nvGrpSpPr>
            <p:cNvPr id="72" name="Grupo 71"/>
            <p:cNvGrpSpPr/>
            <p:nvPr/>
          </p:nvGrpSpPr>
          <p:grpSpPr>
            <a:xfrm>
              <a:off x="1119155" y="2554842"/>
              <a:ext cx="10172610" cy="2084307"/>
              <a:chOff x="-1174062" y="3707486"/>
              <a:chExt cx="13916700" cy="3068026"/>
            </a:xfrm>
          </p:grpSpPr>
          <p:graphicFrame>
            <p:nvGraphicFramePr>
              <p:cNvPr id="62" name="Diagrama 61"/>
              <p:cNvGraphicFramePr/>
              <p:nvPr>
                <p:extLst>
                  <p:ext uri="{D42A27DB-BD31-4B8C-83A1-F6EECF244321}">
                    <p14:modId xmlns:p14="http://schemas.microsoft.com/office/powerpoint/2010/main" val="4146654310"/>
                  </p:ext>
                </p:extLst>
              </p:nvPr>
            </p:nvGraphicFramePr>
            <p:xfrm>
              <a:off x="-1174062" y="3820646"/>
              <a:ext cx="5977467" cy="2954866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17" r:lo="rId18" r:qs="rId19" r:cs="rId20"/>
              </a:graphicData>
            </a:graphic>
          </p:graphicFrame>
          <p:graphicFrame>
            <p:nvGraphicFramePr>
              <p:cNvPr id="63" name="Diagrama 62"/>
              <p:cNvGraphicFramePr/>
              <p:nvPr>
                <p:extLst>
                  <p:ext uri="{D42A27DB-BD31-4B8C-83A1-F6EECF244321}">
                    <p14:modId xmlns:p14="http://schemas.microsoft.com/office/powerpoint/2010/main" val="1045429558"/>
                  </p:ext>
                </p:extLst>
              </p:nvPr>
            </p:nvGraphicFramePr>
            <p:xfrm>
              <a:off x="3266129" y="3728557"/>
              <a:ext cx="5977467" cy="2954866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2" r:lo="rId23" r:qs="rId24" r:cs="rId25"/>
              </a:graphicData>
            </a:graphic>
          </p:graphicFrame>
          <p:graphicFrame>
            <p:nvGraphicFramePr>
              <p:cNvPr id="64" name="Diagrama 63"/>
              <p:cNvGraphicFramePr/>
              <p:nvPr>
                <p:extLst>
                  <p:ext uri="{D42A27DB-BD31-4B8C-83A1-F6EECF244321}">
                    <p14:modId xmlns:p14="http://schemas.microsoft.com/office/powerpoint/2010/main" val="2525051904"/>
                  </p:ext>
                </p:extLst>
              </p:nvPr>
            </p:nvGraphicFramePr>
            <p:xfrm>
              <a:off x="6765172" y="3707486"/>
              <a:ext cx="5977466" cy="2954866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7" r:lo="rId28" r:qs="rId29" r:cs="rId30"/>
              </a:graphicData>
            </a:graphic>
          </p:graphicFrame>
        </p:grpSp>
        <p:grpSp>
          <p:nvGrpSpPr>
            <p:cNvPr id="73" name="Grupo 72"/>
            <p:cNvGrpSpPr/>
            <p:nvPr/>
          </p:nvGrpSpPr>
          <p:grpSpPr>
            <a:xfrm>
              <a:off x="1467884" y="4634797"/>
              <a:ext cx="9643817" cy="2133525"/>
              <a:chOff x="-1159870" y="117465"/>
              <a:chExt cx="14961058" cy="3258266"/>
            </a:xfrm>
          </p:grpSpPr>
          <p:graphicFrame>
            <p:nvGraphicFramePr>
              <p:cNvPr id="74" name="Diagrama 73"/>
              <p:cNvGraphicFramePr/>
              <p:nvPr>
                <p:extLst>
                  <p:ext uri="{D42A27DB-BD31-4B8C-83A1-F6EECF244321}">
                    <p14:modId xmlns:p14="http://schemas.microsoft.com/office/powerpoint/2010/main" val="2852168581"/>
                  </p:ext>
                </p:extLst>
              </p:nvPr>
            </p:nvGraphicFramePr>
            <p:xfrm>
              <a:off x="-1159870" y="420866"/>
              <a:ext cx="5977467" cy="2954865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32" r:lo="rId33" r:qs="rId34" r:cs="rId35"/>
              </a:graphicData>
            </a:graphic>
          </p:graphicFrame>
          <p:graphicFrame>
            <p:nvGraphicFramePr>
              <p:cNvPr id="75" name="Diagrama 74"/>
              <p:cNvGraphicFramePr/>
              <p:nvPr>
                <p:extLst>
                  <p:ext uri="{D42A27DB-BD31-4B8C-83A1-F6EECF244321}">
                    <p14:modId xmlns:p14="http://schemas.microsoft.com/office/powerpoint/2010/main" val="1535141706"/>
                  </p:ext>
                </p:extLst>
              </p:nvPr>
            </p:nvGraphicFramePr>
            <p:xfrm>
              <a:off x="3734721" y="296653"/>
              <a:ext cx="5977467" cy="2954867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37" r:lo="rId38" r:qs="rId39" r:cs="rId40"/>
              </a:graphicData>
            </a:graphic>
          </p:graphicFrame>
          <p:graphicFrame>
            <p:nvGraphicFramePr>
              <p:cNvPr id="76" name="Diagrama 75"/>
              <p:cNvGraphicFramePr/>
              <p:nvPr>
                <p:extLst>
                  <p:ext uri="{D42A27DB-BD31-4B8C-83A1-F6EECF244321}">
                    <p14:modId xmlns:p14="http://schemas.microsoft.com/office/powerpoint/2010/main" val="1093527773"/>
                  </p:ext>
                </p:extLst>
              </p:nvPr>
            </p:nvGraphicFramePr>
            <p:xfrm>
              <a:off x="7823719" y="117465"/>
              <a:ext cx="5977469" cy="2954867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42" r:lo="rId43" r:qs="rId44" r:cs="rId45"/>
              </a:graphicData>
            </a:graphic>
          </p:graphicFrame>
        </p:grpSp>
        <p:sp>
          <p:nvSpPr>
            <p:cNvPr id="80" name="Rectángulo 79"/>
            <p:cNvSpPr/>
            <p:nvPr/>
          </p:nvSpPr>
          <p:spPr>
            <a:xfrm>
              <a:off x="1680754" y="32962"/>
              <a:ext cx="9170504" cy="67353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85458" y="465442"/>
            <a:ext cx="257584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. </a:t>
            </a:r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ata.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ry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ship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p-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≤0.01)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gorical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variables i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variables, as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ampl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)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mple 5p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p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etion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tional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arrangement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ndall´s</a:t>
            </a:r>
            <a:r>
              <a:rPr lang="es-ES" sz="1000" smtClean="0">
                <a:latin typeface="Arial" panose="020B0604020202020204" pitchFamily="34" charset="0"/>
                <a:cs typeface="Arial" panose="020B0604020202020204" pitchFamily="34" charset="0"/>
              </a:rPr>
              <a:t> tau_b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2411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240</Words>
  <Application>Microsoft Office PowerPoint</Application>
  <PresentationFormat>Panorámica</PresentationFormat>
  <Paragraphs>7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15</cp:revision>
  <dcterms:created xsi:type="dcterms:W3CDTF">2021-03-18T18:57:54Z</dcterms:created>
  <dcterms:modified xsi:type="dcterms:W3CDTF">2021-03-22T17:23:48Z</dcterms:modified>
</cp:coreProperties>
</file>